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2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3.xml" ContentType="application/vnd.openxmlformats-officedocument.presentationml.notesSlid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414" r:id="rId2"/>
    <p:sldId id="392" r:id="rId3"/>
    <p:sldId id="391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210" userDrawn="1">
          <p15:clr>
            <a:srgbClr val="A4A3A4"/>
          </p15:clr>
        </p15:guide>
        <p15:guide id="3" orient="horz" pos="68" userDrawn="1">
          <p15:clr>
            <a:srgbClr val="A4A3A4"/>
          </p15:clr>
        </p15:guide>
        <p15:guide id="5" orient="horz" pos="3674" userDrawn="1">
          <p15:clr>
            <a:srgbClr val="A4A3A4"/>
          </p15:clr>
        </p15:guide>
        <p15:guide id="7" pos="4269" userDrawn="1">
          <p15:clr>
            <a:srgbClr val="A4A3A4"/>
          </p15:clr>
        </p15:guide>
        <p15:guide id="8" pos="225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0000"/>
    <a:srgbClr val="32CD32"/>
    <a:srgbClr val="A6A6A6"/>
    <a:srgbClr val="000000"/>
    <a:srgbClr val="6A5ACD"/>
    <a:srgbClr val="BEBEBE"/>
    <a:srgbClr val="FF8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1" autoAdjust="0"/>
    <p:restoredTop sz="96357" autoAdjust="0"/>
  </p:normalViewPr>
  <p:slideViewPr>
    <p:cSldViewPr snapToGrid="0">
      <p:cViewPr varScale="1">
        <p:scale>
          <a:sx n="51" d="100"/>
          <a:sy n="51" d="100"/>
        </p:scale>
        <p:origin x="2256" y="90"/>
      </p:cViewPr>
      <p:guideLst>
        <p:guide orient="horz" pos="1020"/>
        <p:guide pos="210"/>
        <p:guide orient="horz" pos="68"/>
        <p:guide orient="horz" pos="3674"/>
        <p:guide pos="4269"/>
        <p:guide pos="225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380716935269068E-2"/>
          <c:y val="5.5065124265075704E-2"/>
          <c:w val="0.87278286765250168"/>
          <c:h val="0.8898697514698485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AI$14:$AI$17</c:f>
                <c:numCache>
                  <c:formatCode>General</c:formatCode>
                  <c:ptCount val="4"/>
                  <c:pt idx="0">
                    <c:v>0.15451750344825699</c:v>
                  </c:pt>
                  <c:pt idx="1">
                    <c:v>0.15451750344825699</c:v>
                  </c:pt>
                  <c:pt idx="2">
                    <c:v>0.166897978868916</c:v>
                  </c:pt>
                  <c:pt idx="3">
                    <c:v>0.166897978868916</c:v>
                  </c:pt>
                </c:numCache>
              </c:numRef>
            </c:plus>
            <c:minus>
              <c:numRef>
                <c:f>Sheet3!$AI$14:$AI$17</c:f>
                <c:numCache>
                  <c:formatCode>General</c:formatCode>
                  <c:ptCount val="4"/>
                  <c:pt idx="0">
                    <c:v>0.15451750344825699</c:v>
                  </c:pt>
                  <c:pt idx="1">
                    <c:v>0.15451750344825699</c:v>
                  </c:pt>
                  <c:pt idx="2">
                    <c:v>0.166897978868916</c:v>
                  </c:pt>
                  <c:pt idx="3">
                    <c:v>0.1668979788689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3!$AH$14:$AH$17</c:f>
              <c:numCache>
                <c:formatCode>General</c:formatCode>
                <c:ptCount val="4"/>
                <c:pt idx="0">
                  <c:v>1.0125</c:v>
                </c:pt>
                <c:pt idx="1">
                  <c:v>1.12757142857143</c:v>
                </c:pt>
                <c:pt idx="2">
                  <c:v>1.2545833333333301</c:v>
                </c:pt>
                <c:pt idx="3">
                  <c:v>2.3289166666666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B5-438F-B04F-3A258C6F46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743422952"/>
        <c:axId val="743427544"/>
      </c:barChart>
      <c:catAx>
        <c:axId val="74342295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noFill/>
          <a:ln w="9525" cap="flat" cmpd="sng" algn="ctr">
            <a:solidFill>
              <a:schemeClr val="bg1">
                <a:lumMod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3427544"/>
        <c:crossesAt val="0"/>
        <c:auto val="1"/>
        <c:lblAlgn val="ctr"/>
        <c:lblOffset val="100"/>
        <c:noMultiLvlLbl val="0"/>
      </c:catAx>
      <c:valAx>
        <c:axId val="743427544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one"/>
        <c:spPr>
          <a:noFill/>
          <a:ln>
            <a:solidFill>
              <a:schemeClr val="bg1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434229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K$14:$K$17</c:f>
                <c:numCache>
                  <c:formatCode>General</c:formatCode>
                  <c:ptCount val="4"/>
                  <c:pt idx="0">
                    <c:v>0.19992501118955699</c:v>
                  </c:pt>
                  <c:pt idx="1">
                    <c:v>0.14670485039803099</c:v>
                  </c:pt>
                  <c:pt idx="2">
                    <c:v>0.19992501118955699</c:v>
                  </c:pt>
                  <c:pt idx="3">
                    <c:v>0.15948498666703101</c:v>
                  </c:pt>
                </c:numCache>
              </c:numRef>
            </c:plus>
            <c:minus>
              <c:numRef>
                <c:f>Sheet3!$K$14:$K$17</c:f>
                <c:numCache>
                  <c:formatCode>General</c:formatCode>
                  <c:ptCount val="4"/>
                  <c:pt idx="0">
                    <c:v>0.19992501118955699</c:v>
                  </c:pt>
                  <c:pt idx="1">
                    <c:v>0.14670485039803099</c:v>
                  </c:pt>
                  <c:pt idx="2">
                    <c:v>0.19992501118955699</c:v>
                  </c:pt>
                  <c:pt idx="3">
                    <c:v>0.159484986667031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3!$J$14:$J$17</c:f>
              <c:numCache>
                <c:formatCode>General</c:formatCode>
                <c:ptCount val="4"/>
                <c:pt idx="0">
                  <c:v>0.82085714285714295</c:v>
                </c:pt>
                <c:pt idx="1">
                  <c:v>0.67107692307692202</c:v>
                </c:pt>
                <c:pt idx="2">
                  <c:v>1.1654285714285699</c:v>
                </c:pt>
                <c:pt idx="3">
                  <c:v>2.1240909090909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76-4CC4-B310-2C8D7F4DDB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743417048"/>
        <c:axId val="743411800"/>
      </c:barChart>
      <c:catAx>
        <c:axId val="74341704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noFill/>
          <a:ln w="9525" cap="flat" cmpd="sng" algn="ctr">
            <a:solidFill>
              <a:schemeClr val="bg1">
                <a:lumMod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3411800"/>
        <c:crosses val="autoZero"/>
        <c:auto val="1"/>
        <c:lblAlgn val="ctr"/>
        <c:lblOffset val="100"/>
        <c:noMultiLvlLbl val="0"/>
      </c:catAx>
      <c:valAx>
        <c:axId val="743411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bg1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43417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43171289303579"/>
          <c:y val="5.5065124265075704E-2"/>
          <c:w val="0.85592655537193907"/>
          <c:h val="0.8898697514698485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CQ$12:$CQ$15</c:f>
                <c:numCache>
                  <c:formatCode>General</c:formatCode>
                  <c:ptCount val="4"/>
                  <c:pt idx="0">
                    <c:v>0.15061261099895101</c:v>
                  </c:pt>
                  <c:pt idx="1">
                    <c:v>0.15061261099895101</c:v>
                  </c:pt>
                  <c:pt idx="2">
                    <c:v>0.21299839713914001</c:v>
                  </c:pt>
                  <c:pt idx="3">
                    <c:v>0.21299839713914001</c:v>
                  </c:pt>
                </c:numCache>
              </c:numRef>
            </c:plus>
            <c:minus>
              <c:numRef>
                <c:f>Sheet3!$CQ$12:$CQ$15</c:f>
                <c:numCache>
                  <c:formatCode>General</c:formatCode>
                  <c:ptCount val="4"/>
                  <c:pt idx="0">
                    <c:v>0.15061261099895101</c:v>
                  </c:pt>
                  <c:pt idx="1">
                    <c:v>0.15061261099895101</c:v>
                  </c:pt>
                  <c:pt idx="2">
                    <c:v>0.21299839713914001</c:v>
                  </c:pt>
                  <c:pt idx="3">
                    <c:v>0.21299839713914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3!$CP$12:$CP$15</c:f>
              <c:numCache>
                <c:formatCode>General</c:formatCode>
                <c:ptCount val="4"/>
                <c:pt idx="0">
                  <c:v>1.1447499999999999</c:v>
                </c:pt>
                <c:pt idx="1">
                  <c:v>0.79437500000000005</c:v>
                </c:pt>
                <c:pt idx="2">
                  <c:v>1.4910000000000001</c:v>
                </c:pt>
                <c:pt idx="3">
                  <c:v>1.0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0F3-4655-A46E-4E6024577C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743437712"/>
        <c:axId val="743435088"/>
      </c:barChart>
      <c:catAx>
        <c:axId val="743437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3435088"/>
        <c:crosses val="autoZero"/>
        <c:auto val="1"/>
        <c:lblAlgn val="ctr"/>
        <c:lblOffset val="100"/>
        <c:noMultiLvlLbl val="0"/>
      </c:catAx>
      <c:valAx>
        <c:axId val="743435088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bg1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43437712"/>
        <c:crosses val="autoZero"/>
        <c:crossBetween val="between"/>
        <c:majorUnit val="0.5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ilr3'!$O$2:$O$11</c:f>
                <c:numCache>
                  <c:formatCode>General</c:formatCode>
                  <c:ptCount val="10"/>
                  <c:pt idx="0">
                    <c:v>4.1155653416650402E-2</c:v>
                  </c:pt>
                  <c:pt idx="1">
                    <c:v>6.9514783246933304E-2</c:v>
                  </c:pt>
                  <c:pt idx="2">
                    <c:v>0.10982337965640999</c:v>
                  </c:pt>
                  <c:pt idx="3">
                    <c:v>0.19992501118955699</c:v>
                  </c:pt>
                  <c:pt idx="4">
                    <c:v>0.35934793859850001</c:v>
                  </c:pt>
                  <c:pt idx="5">
                    <c:v>0.72396618008224001</c:v>
                  </c:pt>
                  <c:pt idx="6">
                    <c:v>1.02357620311745</c:v>
                  </c:pt>
                  <c:pt idx="7">
                    <c:v>1.3489512717324199</c:v>
                  </c:pt>
                  <c:pt idx="8">
                    <c:v>2.0311035288755401</c:v>
                  </c:pt>
                  <c:pt idx="9">
                    <c:v>2.5539886659961599</c:v>
                  </c:pt>
                </c:numCache>
              </c:numRef>
            </c:plus>
            <c:minus>
              <c:numRef>
                <c:f>'ilr3'!$O$2:$O$11</c:f>
                <c:numCache>
                  <c:formatCode>General</c:formatCode>
                  <c:ptCount val="10"/>
                  <c:pt idx="0">
                    <c:v>4.1155653416650402E-2</c:v>
                  </c:pt>
                  <c:pt idx="1">
                    <c:v>6.9514783246933304E-2</c:v>
                  </c:pt>
                  <c:pt idx="2">
                    <c:v>0.10982337965640999</c:v>
                  </c:pt>
                  <c:pt idx="3">
                    <c:v>0.19992501118955699</c:v>
                  </c:pt>
                  <c:pt idx="4">
                    <c:v>0.35934793859850001</c:v>
                  </c:pt>
                  <c:pt idx="5">
                    <c:v>0.72396618008224001</c:v>
                  </c:pt>
                  <c:pt idx="6">
                    <c:v>1.02357620311745</c:v>
                  </c:pt>
                  <c:pt idx="7">
                    <c:v>1.3489512717324199</c:v>
                  </c:pt>
                  <c:pt idx="8">
                    <c:v>2.0311035288755401</c:v>
                  </c:pt>
                  <c:pt idx="9">
                    <c:v>2.55398866599615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r3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ilr3'!$I$2:$I$11</c:f>
              <c:numCache>
                <c:formatCode>General</c:formatCode>
                <c:ptCount val="10"/>
                <c:pt idx="0">
                  <c:v>0.23499999999999999</c:v>
                </c:pt>
                <c:pt idx="1">
                  <c:v>0.39257142857142802</c:v>
                </c:pt>
                <c:pt idx="2">
                  <c:v>0.64828571428571502</c:v>
                </c:pt>
                <c:pt idx="3">
                  <c:v>0.82085714285714295</c:v>
                </c:pt>
                <c:pt idx="4">
                  <c:v>1.48514285714286</c:v>
                </c:pt>
                <c:pt idx="5">
                  <c:v>2.6298571428571398</c:v>
                </c:pt>
                <c:pt idx="6">
                  <c:v>4.11271428571429</c:v>
                </c:pt>
                <c:pt idx="7">
                  <c:v>5.8574285714285699</c:v>
                </c:pt>
                <c:pt idx="8">
                  <c:v>8.7362857142857209</c:v>
                </c:pt>
                <c:pt idx="9">
                  <c:v>12.73785714285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DDB-4847-A103-82E1D53CE50F}"/>
            </c:ext>
          </c:extLst>
        </c:ser>
        <c:ser>
          <c:idx val="1"/>
          <c:order val="1"/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prstDash val="dash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ilr3'!$P$2:$P$11</c:f>
                <c:numCache>
                  <c:formatCode>General</c:formatCode>
                  <c:ptCount val="10"/>
                  <c:pt idx="0">
                    <c:v>3.0199993195439999E-2</c:v>
                  </c:pt>
                  <c:pt idx="1">
                    <c:v>5.1009905244039699E-2</c:v>
                  </c:pt>
                  <c:pt idx="2">
                    <c:v>8.4489305853617497E-2</c:v>
                  </c:pt>
                  <c:pt idx="3">
                    <c:v>0.14670485039803099</c:v>
                  </c:pt>
                  <c:pt idx="4">
                    <c:v>0.26368929659806101</c:v>
                  </c:pt>
                  <c:pt idx="5">
                    <c:v>0.53124593821579102</c:v>
                  </c:pt>
                  <c:pt idx="6">
                    <c:v>0.75109958907019603</c:v>
                  </c:pt>
                  <c:pt idx="7">
                    <c:v>0.98985961454368998</c:v>
                  </c:pt>
                  <c:pt idx="8">
                    <c:v>1.4912748406888801</c:v>
                  </c:pt>
                  <c:pt idx="9">
                    <c:v>1.8741153142064</c:v>
                  </c:pt>
                </c:numCache>
              </c:numRef>
            </c:plus>
            <c:minus>
              <c:numRef>
                <c:f>'ilr3'!$P$2:$P$11</c:f>
                <c:numCache>
                  <c:formatCode>General</c:formatCode>
                  <c:ptCount val="10"/>
                  <c:pt idx="0">
                    <c:v>3.0199993195439999E-2</c:v>
                  </c:pt>
                  <c:pt idx="1">
                    <c:v>5.1009905244039699E-2</c:v>
                  </c:pt>
                  <c:pt idx="2">
                    <c:v>8.4489305853617497E-2</c:v>
                  </c:pt>
                  <c:pt idx="3">
                    <c:v>0.14670485039803099</c:v>
                  </c:pt>
                  <c:pt idx="4">
                    <c:v>0.26368929659806101</c:v>
                  </c:pt>
                  <c:pt idx="5">
                    <c:v>0.53124593821579102</c:v>
                  </c:pt>
                  <c:pt idx="6">
                    <c:v>0.75109958907019603</c:v>
                  </c:pt>
                  <c:pt idx="7">
                    <c:v>0.98985961454368998</c:v>
                  </c:pt>
                  <c:pt idx="8">
                    <c:v>1.4912748406888801</c:v>
                  </c:pt>
                  <c:pt idx="9">
                    <c:v>1.87411531420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r3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ilr3'!$J$2:$J$11</c:f>
              <c:numCache>
                <c:formatCode>General</c:formatCode>
                <c:ptCount val="10"/>
                <c:pt idx="0">
                  <c:v>0.20707692307692299</c:v>
                </c:pt>
                <c:pt idx="1">
                  <c:v>0.338076923076924</c:v>
                </c:pt>
                <c:pt idx="2">
                  <c:v>0.51803727533061505</c:v>
                </c:pt>
                <c:pt idx="3">
                  <c:v>0.67107692307692202</c:v>
                </c:pt>
                <c:pt idx="4">
                  <c:v>1.09015384615384</c:v>
                </c:pt>
                <c:pt idx="5">
                  <c:v>1.786</c:v>
                </c:pt>
                <c:pt idx="6">
                  <c:v>2.3479999999999999</c:v>
                </c:pt>
                <c:pt idx="7">
                  <c:v>2.8239230769230801</c:v>
                </c:pt>
                <c:pt idx="8">
                  <c:v>3.4505368684993898</c:v>
                </c:pt>
                <c:pt idx="9">
                  <c:v>4.1513076923077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DDB-4847-A103-82E1D53CE50F}"/>
            </c:ext>
          </c:extLst>
        </c:ser>
        <c:ser>
          <c:idx val="2"/>
          <c:order val="2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ilr3'!$Q$2:$Q$11</c:f>
                <c:numCache>
                  <c:formatCode>General</c:formatCode>
                  <c:ptCount val="10"/>
                  <c:pt idx="0">
                    <c:v>4.4453186344475801E-2</c:v>
                  </c:pt>
                  <c:pt idx="1">
                    <c:v>6.9514783246933304E-2</c:v>
                  </c:pt>
                  <c:pt idx="2">
                    <c:v>0.10982337965640999</c:v>
                  </c:pt>
                  <c:pt idx="3">
                    <c:v>0.19992501118955699</c:v>
                  </c:pt>
                  <c:pt idx="4">
                    <c:v>0.35934793859850001</c:v>
                  </c:pt>
                  <c:pt idx="5">
                    <c:v>0.72396618008224001</c:v>
                  </c:pt>
                  <c:pt idx="6">
                    <c:v>1.02357620311745</c:v>
                  </c:pt>
                  <c:pt idx="7">
                    <c:v>1.3489512717324199</c:v>
                  </c:pt>
                  <c:pt idx="8">
                    <c:v>2.0311035288755401</c:v>
                  </c:pt>
                  <c:pt idx="9">
                    <c:v>2.5539886659961599</c:v>
                  </c:pt>
                </c:numCache>
              </c:numRef>
            </c:plus>
            <c:minus>
              <c:numRef>
                <c:f>'ilr3'!$Q$2:$Q$11</c:f>
                <c:numCache>
                  <c:formatCode>General</c:formatCode>
                  <c:ptCount val="10"/>
                  <c:pt idx="0">
                    <c:v>4.4453186344475801E-2</c:v>
                  </c:pt>
                  <c:pt idx="1">
                    <c:v>6.9514783246933304E-2</c:v>
                  </c:pt>
                  <c:pt idx="2">
                    <c:v>0.10982337965640999</c:v>
                  </c:pt>
                  <c:pt idx="3">
                    <c:v>0.19992501118955699</c:v>
                  </c:pt>
                  <c:pt idx="4">
                    <c:v>0.35934793859850001</c:v>
                  </c:pt>
                  <c:pt idx="5">
                    <c:v>0.72396618008224001</c:v>
                  </c:pt>
                  <c:pt idx="6">
                    <c:v>1.02357620311745</c:v>
                  </c:pt>
                  <c:pt idx="7">
                    <c:v>1.3489512717324199</c:v>
                  </c:pt>
                  <c:pt idx="8">
                    <c:v>2.0311035288755401</c:v>
                  </c:pt>
                  <c:pt idx="9">
                    <c:v>2.55398866599615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r3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ilr3'!$K$2:$K$11</c:f>
              <c:numCache>
                <c:formatCode>General</c:formatCode>
                <c:ptCount val="10"/>
                <c:pt idx="0">
                  <c:v>0.31333333333333302</c:v>
                </c:pt>
                <c:pt idx="1">
                  <c:v>0.45528571428571402</c:v>
                </c:pt>
                <c:pt idx="2">
                  <c:v>0.64257142857142902</c:v>
                </c:pt>
                <c:pt idx="3">
                  <c:v>1.1654285714285699</c:v>
                </c:pt>
                <c:pt idx="4">
                  <c:v>2.2498571428571399</c:v>
                </c:pt>
                <c:pt idx="5">
                  <c:v>4.1964285714285703</c:v>
                </c:pt>
                <c:pt idx="6">
                  <c:v>8.3859999999999992</c:v>
                </c:pt>
                <c:pt idx="7">
                  <c:v>11.8642857142857</c:v>
                </c:pt>
                <c:pt idx="8">
                  <c:v>19.199857142857098</c:v>
                </c:pt>
                <c:pt idx="9">
                  <c:v>28.04271428571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DDB-4847-A103-82E1D53CE50F}"/>
            </c:ext>
          </c:extLst>
        </c:ser>
        <c:ser>
          <c:idx val="3"/>
          <c:order val="3"/>
          <c:spPr>
            <a:ln w="28575" cap="rnd">
              <a:solidFill>
                <a:schemeClr val="accent2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  <a:prstDash val="dash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ilr3'!$R$2:$R$11</c:f>
                <c:numCache>
                  <c:formatCode>General</c:formatCode>
                  <c:ptCount val="10"/>
                  <c:pt idx="0">
                    <c:v>3.2830853915541802E-2</c:v>
                  </c:pt>
                  <c:pt idx="1">
                    <c:v>5.5453613399011101E-2</c:v>
                  </c:pt>
                  <c:pt idx="2">
                    <c:v>9.0858954163797703E-2</c:v>
                  </c:pt>
                  <c:pt idx="3">
                    <c:v>0.15948498666703101</c:v>
                  </c:pt>
                  <c:pt idx="4">
                    <c:v>0.28666048762587398</c:v>
                  </c:pt>
                  <c:pt idx="5">
                    <c:v>0.57752522253617899</c:v>
                  </c:pt>
                  <c:pt idx="6">
                    <c:v>0.81653133910342801</c:v>
                  </c:pt>
                  <c:pt idx="7">
                    <c:v>1.07609085179812</c:v>
                  </c:pt>
                  <c:pt idx="8">
                    <c:v>1.62098986482398</c:v>
                  </c:pt>
                  <c:pt idx="9">
                    <c:v>2.0373781445381298</c:v>
                  </c:pt>
                </c:numCache>
              </c:numRef>
            </c:plus>
            <c:minus>
              <c:numRef>
                <c:f>'ilr3'!$R$2:$R$11</c:f>
                <c:numCache>
                  <c:formatCode>General</c:formatCode>
                  <c:ptCount val="10"/>
                  <c:pt idx="0">
                    <c:v>3.2830853915541802E-2</c:v>
                  </c:pt>
                  <c:pt idx="1">
                    <c:v>5.5453613399011101E-2</c:v>
                  </c:pt>
                  <c:pt idx="2">
                    <c:v>9.0858954163797703E-2</c:v>
                  </c:pt>
                  <c:pt idx="3">
                    <c:v>0.15948498666703101</c:v>
                  </c:pt>
                  <c:pt idx="4">
                    <c:v>0.28666048762587398</c:v>
                  </c:pt>
                  <c:pt idx="5">
                    <c:v>0.57752522253617899</c:v>
                  </c:pt>
                  <c:pt idx="6">
                    <c:v>0.81653133910342801</c:v>
                  </c:pt>
                  <c:pt idx="7">
                    <c:v>1.07609085179812</c:v>
                  </c:pt>
                  <c:pt idx="8">
                    <c:v>1.62098986482398</c:v>
                  </c:pt>
                  <c:pt idx="9">
                    <c:v>2.03737814453812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ilr3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ilr3'!$L$2:$L$11</c:f>
              <c:numCache>
                <c:formatCode>General</c:formatCode>
                <c:ptCount val="10"/>
                <c:pt idx="0">
                  <c:v>0.49354545454545501</c:v>
                </c:pt>
                <c:pt idx="1">
                  <c:v>0.76236363636363602</c:v>
                </c:pt>
                <c:pt idx="2">
                  <c:v>1.2898138809125399</c:v>
                </c:pt>
                <c:pt idx="3">
                  <c:v>2.1240909090909099</c:v>
                </c:pt>
                <c:pt idx="4">
                  <c:v>3.4593636363636402</c:v>
                </c:pt>
                <c:pt idx="5">
                  <c:v>6.02136363636364</c:v>
                </c:pt>
                <c:pt idx="6">
                  <c:v>8.0356363636363604</c:v>
                </c:pt>
                <c:pt idx="7">
                  <c:v>10.756090909090901</c:v>
                </c:pt>
                <c:pt idx="8">
                  <c:v>13.076759020714</c:v>
                </c:pt>
                <c:pt idx="9">
                  <c:v>13.97772727272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DDB-4847-A103-82E1D53CE5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7956240"/>
        <c:axId val="507953616"/>
      </c:lineChart>
      <c:catAx>
        <c:axId val="5079562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953616"/>
        <c:crosses val="autoZero"/>
        <c:auto val="1"/>
        <c:lblAlgn val="ctr"/>
        <c:lblOffset val="100"/>
        <c:noMultiLvlLbl val="0"/>
      </c:catAx>
      <c:valAx>
        <c:axId val="507953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6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9562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bf4'!$O$2:$O$11</c:f>
                <c:numCache>
                  <c:formatCode>General</c:formatCode>
                  <c:ptCount val="10"/>
                  <c:pt idx="0">
                    <c:v>4.4182054119857303E-2</c:v>
                  </c:pt>
                  <c:pt idx="1">
                    <c:v>5.4222602528834797E-2</c:v>
                  </c:pt>
                  <c:pt idx="2">
                    <c:v>9.6019805899616298E-2</c:v>
                  </c:pt>
                  <c:pt idx="3">
                    <c:v>0.15061261099895101</c:v>
                  </c:pt>
                  <c:pt idx="4">
                    <c:v>0.29079033200486598</c:v>
                  </c:pt>
                  <c:pt idx="5">
                    <c:v>0.47193401038307198</c:v>
                  </c:pt>
                  <c:pt idx="6">
                    <c:v>0.75291770633715305</c:v>
                  </c:pt>
                  <c:pt idx="7">
                    <c:v>1.3444744381356999</c:v>
                  </c:pt>
                  <c:pt idx="8">
                    <c:v>1.84655521601227</c:v>
                  </c:pt>
                  <c:pt idx="9">
                    <c:v>2.0034085772580301</c:v>
                  </c:pt>
                </c:numCache>
              </c:numRef>
            </c:plus>
            <c:minus>
              <c:numRef>
                <c:f>'abf4'!$O$2:$O$11</c:f>
                <c:numCache>
                  <c:formatCode>General</c:formatCode>
                  <c:ptCount val="10"/>
                  <c:pt idx="0">
                    <c:v>4.4182054119857303E-2</c:v>
                  </c:pt>
                  <c:pt idx="1">
                    <c:v>5.4222602528834797E-2</c:v>
                  </c:pt>
                  <c:pt idx="2">
                    <c:v>9.6019805899616298E-2</c:v>
                  </c:pt>
                  <c:pt idx="3">
                    <c:v>0.15061261099895101</c:v>
                  </c:pt>
                  <c:pt idx="4">
                    <c:v>0.29079033200486598</c:v>
                  </c:pt>
                  <c:pt idx="5">
                    <c:v>0.47193401038307198</c:v>
                  </c:pt>
                  <c:pt idx="6">
                    <c:v>0.75291770633715305</c:v>
                  </c:pt>
                  <c:pt idx="7">
                    <c:v>1.3444744381356999</c:v>
                  </c:pt>
                  <c:pt idx="8">
                    <c:v>1.84655521601227</c:v>
                  </c:pt>
                  <c:pt idx="9">
                    <c:v>2.00340857725803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bf4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abf4'!$I$2:$I$11</c:f>
              <c:numCache>
                <c:formatCode>General</c:formatCode>
                <c:ptCount val="10"/>
                <c:pt idx="0">
                  <c:v>0.30862499999999998</c:v>
                </c:pt>
                <c:pt idx="1">
                  <c:v>0.47512500000000002</c:v>
                </c:pt>
                <c:pt idx="2">
                  <c:v>0.74775000000000003</c:v>
                </c:pt>
                <c:pt idx="3">
                  <c:v>1.1447499999999999</c:v>
                </c:pt>
                <c:pt idx="4">
                  <c:v>2.2062499999999998</c:v>
                </c:pt>
                <c:pt idx="5">
                  <c:v>3.734</c:v>
                </c:pt>
                <c:pt idx="6">
                  <c:v>5.8218750000000004</c:v>
                </c:pt>
                <c:pt idx="7">
                  <c:v>9.4934999999999992</c:v>
                </c:pt>
                <c:pt idx="8">
                  <c:v>14.128875000000001</c:v>
                </c:pt>
                <c:pt idx="9">
                  <c:v>19.893125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7D1-4E92-8D57-6808B6727744}"/>
            </c:ext>
          </c:extLst>
        </c:ser>
        <c:ser>
          <c:idx val="1"/>
          <c:order val="1"/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prstDash val="dash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bf4'!$P$2:$P$11</c:f>
                <c:numCache>
                  <c:formatCode>General</c:formatCode>
                  <c:ptCount val="10"/>
                  <c:pt idx="0">
                    <c:v>4.4182054119857303E-2</c:v>
                  </c:pt>
                  <c:pt idx="1">
                    <c:v>5.4222602528834797E-2</c:v>
                  </c:pt>
                  <c:pt idx="2">
                    <c:v>9.6019805899616395E-2</c:v>
                  </c:pt>
                  <c:pt idx="3">
                    <c:v>0.15061261099895101</c:v>
                  </c:pt>
                  <c:pt idx="4">
                    <c:v>0.29079033200486598</c:v>
                  </c:pt>
                  <c:pt idx="5">
                    <c:v>0.47193401038307298</c:v>
                  </c:pt>
                  <c:pt idx="6">
                    <c:v>0.75291770633715305</c:v>
                  </c:pt>
                  <c:pt idx="7">
                    <c:v>1.3444744381356999</c:v>
                  </c:pt>
                  <c:pt idx="8">
                    <c:v>1.84655521601227</c:v>
                  </c:pt>
                  <c:pt idx="9">
                    <c:v>2.0034085772580301</c:v>
                  </c:pt>
                </c:numCache>
              </c:numRef>
            </c:plus>
            <c:minus>
              <c:numRef>
                <c:f>'abf4'!$P$2:$P$11</c:f>
                <c:numCache>
                  <c:formatCode>General</c:formatCode>
                  <c:ptCount val="10"/>
                  <c:pt idx="0">
                    <c:v>4.4182054119857303E-2</c:v>
                  </c:pt>
                  <c:pt idx="1">
                    <c:v>5.4222602528834797E-2</c:v>
                  </c:pt>
                  <c:pt idx="2">
                    <c:v>9.6019805899616395E-2</c:v>
                  </c:pt>
                  <c:pt idx="3">
                    <c:v>0.15061261099895101</c:v>
                  </c:pt>
                  <c:pt idx="4">
                    <c:v>0.29079033200486598</c:v>
                  </c:pt>
                  <c:pt idx="5">
                    <c:v>0.47193401038307298</c:v>
                  </c:pt>
                  <c:pt idx="6">
                    <c:v>0.75291770633715305</c:v>
                  </c:pt>
                  <c:pt idx="7">
                    <c:v>1.3444744381356999</c:v>
                  </c:pt>
                  <c:pt idx="8">
                    <c:v>1.84655521601227</c:v>
                  </c:pt>
                  <c:pt idx="9">
                    <c:v>2.00340857725803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bf4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abf4'!$J$2:$J$11</c:f>
              <c:numCache>
                <c:formatCode>General</c:formatCode>
                <c:ptCount val="10"/>
                <c:pt idx="0">
                  <c:v>0.214</c:v>
                </c:pt>
                <c:pt idx="1">
                  <c:v>0.35337499999999999</c:v>
                </c:pt>
                <c:pt idx="2">
                  <c:v>0.54075000000000095</c:v>
                </c:pt>
                <c:pt idx="3">
                  <c:v>0.79437500000000005</c:v>
                </c:pt>
                <c:pt idx="4">
                  <c:v>1.44425</c:v>
                </c:pt>
                <c:pt idx="5">
                  <c:v>2.4838749999999998</c:v>
                </c:pt>
                <c:pt idx="6">
                  <c:v>3.8849999999999998</c:v>
                </c:pt>
                <c:pt idx="7">
                  <c:v>6.8471250000000099</c:v>
                </c:pt>
                <c:pt idx="8">
                  <c:v>10.082125</c:v>
                </c:pt>
                <c:pt idx="9">
                  <c:v>14.996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7D1-4E92-8D57-6808B6727744}"/>
            </c:ext>
          </c:extLst>
        </c:ser>
        <c:ser>
          <c:idx val="2"/>
          <c:order val="2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bf4'!$Q$2:$Q$11</c:f>
                <c:numCache>
                  <c:formatCode>General</c:formatCode>
                  <c:ptCount val="10"/>
                  <c:pt idx="0">
                    <c:v>6.2482860149804302E-2</c:v>
                  </c:pt>
                  <c:pt idx="1">
                    <c:v>7.6682339883443806E-2</c:v>
                  </c:pt>
                  <c:pt idx="2">
                    <c:v>0.13579251175967</c:v>
                  </c:pt>
                  <c:pt idx="3">
                    <c:v>0.21299839713914001</c:v>
                  </c:pt>
                  <c:pt idx="4">
                    <c:v>0.41123963132825597</c:v>
                  </c:pt>
                  <c:pt idx="5">
                    <c:v>0.66741547802886603</c:v>
                  </c:pt>
                  <c:pt idx="6">
                    <c:v>1.0647864316528399</c:v>
                  </c:pt>
                  <c:pt idx="7">
                    <c:v>1.90137398467545</c:v>
                  </c:pt>
                  <c:pt idx="8">
                    <c:v>2.6114234301553299</c:v>
                  </c:pt>
                  <c:pt idx="9">
                    <c:v>2.8332475809328899</c:v>
                  </c:pt>
                </c:numCache>
              </c:numRef>
            </c:plus>
            <c:minus>
              <c:numRef>
                <c:f>'abf4'!$Q$2:$Q$11</c:f>
                <c:numCache>
                  <c:formatCode>General</c:formatCode>
                  <c:ptCount val="10"/>
                  <c:pt idx="0">
                    <c:v>6.2482860149804302E-2</c:v>
                  </c:pt>
                  <c:pt idx="1">
                    <c:v>7.6682339883443806E-2</c:v>
                  </c:pt>
                  <c:pt idx="2">
                    <c:v>0.13579251175967</c:v>
                  </c:pt>
                  <c:pt idx="3">
                    <c:v>0.21299839713914001</c:v>
                  </c:pt>
                  <c:pt idx="4">
                    <c:v>0.41123963132825597</c:v>
                  </c:pt>
                  <c:pt idx="5">
                    <c:v>0.66741547802886603</c:v>
                  </c:pt>
                  <c:pt idx="6">
                    <c:v>1.0647864316528399</c:v>
                  </c:pt>
                  <c:pt idx="7">
                    <c:v>1.90137398467545</c:v>
                  </c:pt>
                  <c:pt idx="8">
                    <c:v>2.6114234301553299</c:v>
                  </c:pt>
                  <c:pt idx="9">
                    <c:v>2.83324758093288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bf4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abf4'!$K$2:$K$11</c:f>
              <c:numCache>
                <c:formatCode>General</c:formatCode>
                <c:ptCount val="10"/>
                <c:pt idx="0">
                  <c:v>0.27200000000000002</c:v>
                </c:pt>
                <c:pt idx="1">
                  <c:v>0.44750000000000001</c:v>
                </c:pt>
                <c:pt idx="2">
                  <c:v>0.71425000000000005</c:v>
                </c:pt>
                <c:pt idx="3">
                  <c:v>1.4910000000000001</c:v>
                </c:pt>
                <c:pt idx="4">
                  <c:v>2.6934999999999998</c:v>
                </c:pt>
                <c:pt idx="5">
                  <c:v>4.5119999999999996</c:v>
                </c:pt>
                <c:pt idx="6">
                  <c:v>9.4717500000000001</c:v>
                </c:pt>
                <c:pt idx="7">
                  <c:v>14.45725</c:v>
                </c:pt>
                <c:pt idx="8">
                  <c:v>19.437750000000001</c:v>
                </c:pt>
                <c:pt idx="9">
                  <c:v>29.265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7D1-4E92-8D57-6808B6727744}"/>
            </c:ext>
          </c:extLst>
        </c:ser>
        <c:ser>
          <c:idx val="3"/>
          <c:order val="3"/>
          <c:spPr>
            <a:ln w="28575" cap="rnd">
              <a:solidFill>
                <a:schemeClr val="accent2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  <a:prstDash val="dash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bf4'!$R$2:$R$11</c:f>
                <c:numCache>
                  <c:formatCode>General</c:formatCode>
                  <c:ptCount val="10"/>
                  <c:pt idx="0">
                    <c:v>6.2482860149804302E-2</c:v>
                  </c:pt>
                  <c:pt idx="1">
                    <c:v>7.6682339883443806E-2</c:v>
                  </c:pt>
                  <c:pt idx="2">
                    <c:v>0.13579251175967</c:v>
                  </c:pt>
                  <c:pt idx="3">
                    <c:v>0.21299839713914001</c:v>
                  </c:pt>
                  <c:pt idx="4">
                    <c:v>0.41123963132825597</c:v>
                  </c:pt>
                  <c:pt idx="5">
                    <c:v>0.66741547802886603</c:v>
                  </c:pt>
                  <c:pt idx="6">
                    <c:v>1.0647864316528499</c:v>
                  </c:pt>
                  <c:pt idx="7">
                    <c:v>1.90137398467545</c:v>
                  </c:pt>
                  <c:pt idx="8">
                    <c:v>2.6114234301553299</c:v>
                  </c:pt>
                  <c:pt idx="9">
                    <c:v>2.8332475809328899</c:v>
                  </c:pt>
                </c:numCache>
              </c:numRef>
            </c:plus>
            <c:minus>
              <c:numRef>
                <c:f>'abf4'!$R$2:$R$11</c:f>
                <c:numCache>
                  <c:formatCode>General</c:formatCode>
                  <c:ptCount val="10"/>
                  <c:pt idx="0">
                    <c:v>6.2482860149804302E-2</c:v>
                  </c:pt>
                  <c:pt idx="1">
                    <c:v>7.6682339883443806E-2</c:v>
                  </c:pt>
                  <c:pt idx="2">
                    <c:v>0.13579251175967</c:v>
                  </c:pt>
                  <c:pt idx="3">
                    <c:v>0.21299839713914001</c:v>
                  </c:pt>
                  <c:pt idx="4">
                    <c:v>0.41123963132825597</c:v>
                  </c:pt>
                  <c:pt idx="5">
                    <c:v>0.66741547802886603</c:v>
                  </c:pt>
                  <c:pt idx="6">
                    <c:v>1.0647864316528499</c:v>
                  </c:pt>
                  <c:pt idx="7">
                    <c:v>1.90137398467545</c:v>
                  </c:pt>
                  <c:pt idx="8">
                    <c:v>2.6114234301553299</c:v>
                  </c:pt>
                  <c:pt idx="9">
                    <c:v>2.83324758093288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bf4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abf4'!$L$2:$L$11</c:f>
              <c:numCache>
                <c:formatCode>General</c:formatCode>
                <c:ptCount val="10"/>
                <c:pt idx="0">
                  <c:v>0.36325000000000002</c:v>
                </c:pt>
                <c:pt idx="1">
                  <c:v>0.47575000000000001</c:v>
                </c:pt>
                <c:pt idx="2">
                  <c:v>0.76475000000000004</c:v>
                </c:pt>
                <c:pt idx="3">
                  <c:v>1.071</c:v>
                </c:pt>
                <c:pt idx="4">
                  <c:v>1.96275</c:v>
                </c:pt>
                <c:pt idx="5">
                  <c:v>3.1412499999999999</c:v>
                </c:pt>
                <c:pt idx="6">
                  <c:v>5.6070000000000002</c:v>
                </c:pt>
                <c:pt idx="7">
                  <c:v>8.7242499999999996</c:v>
                </c:pt>
                <c:pt idx="8">
                  <c:v>13.65325</c:v>
                </c:pt>
                <c:pt idx="9">
                  <c:v>17.611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7D1-4E92-8D57-6808B67277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19098760"/>
        <c:axId val="719098432"/>
      </c:lineChart>
      <c:catAx>
        <c:axId val="719098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9098432"/>
        <c:crosses val="autoZero"/>
        <c:auto val="1"/>
        <c:lblAlgn val="ctr"/>
        <c:lblOffset val="100"/>
        <c:noMultiLvlLbl val="0"/>
      </c:catAx>
      <c:valAx>
        <c:axId val="719098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6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90987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prstDash val="solid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bf4'!$O$2:$O$11</c:f>
                <c:numCache>
                  <c:formatCode>General</c:formatCode>
                  <c:ptCount val="10"/>
                  <c:pt idx="0">
                    <c:v>2.46881953526021E-2</c:v>
                  </c:pt>
                  <c:pt idx="1">
                    <c:v>4.1643518013759102E-2</c:v>
                  </c:pt>
                  <c:pt idx="2">
                    <c:v>7.6210096073408007E-2</c:v>
                  </c:pt>
                  <c:pt idx="3">
                    <c:v>0.15451750344825699</c:v>
                  </c:pt>
                  <c:pt idx="4">
                    <c:v>0.30307398038273398</c:v>
                  </c:pt>
                  <c:pt idx="5">
                    <c:v>0.64376343424344096</c:v>
                  </c:pt>
                  <c:pt idx="6">
                    <c:v>0.96969330287125399</c:v>
                  </c:pt>
                  <c:pt idx="7">
                    <c:v>1.4579630205534899</c:v>
                  </c:pt>
                  <c:pt idx="8">
                    <c:v>2.02428587074189</c:v>
                  </c:pt>
                  <c:pt idx="9">
                    <c:v>2.3145599957966798</c:v>
                  </c:pt>
                </c:numCache>
              </c:numRef>
            </c:plus>
            <c:minus>
              <c:numRef>
                <c:f>'cbf4'!$O$2:$O$11</c:f>
                <c:numCache>
                  <c:formatCode>General</c:formatCode>
                  <c:ptCount val="10"/>
                  <c:pt idx="0">
                    <c:v>2.46881953526021E-2</c:v>
                  </c:pt>
                  <c:pt idx="1">
                    <c:v>4.1643518013759102E-2</c:v>
                  </c:pt>
                  <c:pt idx="2">
                    <c:v>7.6210096073408007E-2</c:v>
                  </c:pt>
                  <c:pt idx="3">
                    <c:v>0.15451750344825699</c:v>
                  </c:pt>
                  <c:pt idx="4">
                    <c:v>0.30307398038273398</c:v>
                  </c:pt>
                  <c:pt idx="5">
                    <c:v>0.64376343424344096</c:v>
                  </c:pt>
                  <c:pt idx="6">
                    <c:v>0.96969330287125399</c:v>
                  </c:pt>
                  <c:pt idx="7">
                    <c:v>1.4579630205534899</c:v>
                  </c:pt>
                  <c:pt idx="8">
                    <c:v>2.02428587074189</c:v>
                  </c:pt>
                  <c:pt idx="9">
                    <c:v>2.31455999579667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bf4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cbf4'!$I$2:$I$11</c:f>
              <c:numCache>
                <c:formatCode>General</c:formatCode>
                <c:ptCount val="10"/>
                <c:pt idx="0">
                  <c:v>0.28235714285714297</c:v>
                </c:pt>
                <c:pt idx="1">
                  <c:v>0.44578571428571401</c:v>
                </c:pt>
                <c:pt idx="2">
                  <c:v>0.71350000000000002</c:v>
                </c:pt>
                <c:pt idx="3">
                  <c:v>1.0125</c:v>
                </c:pt>
                <c:pt idx="4">
                  <c:v>1.9219285714285701</c:v>
                </c:pt>
                <c:pt idx="5">
                  <c:v>3.29028571428571</c:v>
                </c:pt>
                <c:pt idx="6">
                  <c:v>5.12</c:v>
                </c:pt>
                <c:pt idx="7">
                  <c:v>7.9447857142857101</c:v>
                </c:pt>
                <c:pt idx="8">
                  <c:v>11.8351428571429</c:v>
                </c:pt>
                <c:pt idx="9">
                  <c:v>16.7734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BAE-4DE2-B693-33E59B726E70}"/>
            </c:ext>
          </c:extLst>
        </c:ser>
        <c:ser>
          <c:idx val="1"/>
          <c:order val="1"/>
          <c:spPr>
            <a:ln w="285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  <a:prstDash val="dash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bf4'!$P$2:$P$11</c:f>
                <c:numCache>
                  <c:formatCode>General</c:formatCode>
                  <c:ptCount val="10"/>
                  <c:pt idx="0">
                    <c:v>2.46881953526021E-2</c:v>
                  </c:pt>
                  <c:pt idx="1">
                    <c:v>4.1643518013759102E-2</c:v>
                  </c:pt>
                  <c:pt idx="2">
                    <c:v>7.6210096073408007E-2</c:v>
                  </c:pt>
                  <c:pt idx="3">
                    <c:v>0.15451750344825699</c:v>
                  </c:pt>
                  <c:pt idx="4">
                    <c:v>0.30307398038273398</c:v>
                  </c:pt>
                  <c:pt idx="5">
                    <c:v>0.64376343424344096</c:v>
                  </c:pt>
                  <c:pt idx="6">
                    <c:v>0.96969330287125399</c:v>
                  </c:pt>
                  <c:pt idx="7">
                    <c:v>1.4579630205534899</c:v>
                  </c:pt>
                  <c:pt idx="8">
                    <c:v>2.02428587074189</c:v>
                  </c:pt>
                  <c:pt idx="9">
                    <c:v>2.3145599957966798</c:v>
                  </c:pt>
                </c:numCache>
              </c:numRef>
            </c:plus>
            <c:minus>
              <c:numRef>
                <c:f>'cbf4'!$P$2:$P$11</c:f>
                <c:numCache>
                  <c:formatCode>General</c:formatCode>
                  <c:ptCount val="10"/>
                  <c:pt idx="0">
                    <c:v>2.46881953526021E-2</c:v>
                  </c:pt>
                  <c:pt idx="1">
                    <c:v>4.1643518013759102E-2</c:v>
                  </c:pt>
                  <c:pt idx="2">
                    <c:v>7.6210096073408007E-2</c:v>
                  </c:pt>
                  <c:pt idx="3">
                    <c:v>0.15451750344825699</c:v>
                  </c:pt>
                  <c:pt idx="4">
                    <c:v>0.30307398038273398</c:v>
                  </c:pt>
                  <c:pt idx="5">
                    <c:v>0.64376343424344096</c:v>
                  </c:pt>
                  <c:pt idx="6">
                    <c:v>0.96969330287125399</c:v>
                  </c:pt>
                  <c:pt idx="7">
                    <c:v>1.4579630205534899</c:v>
                  </c:pt>
                  <c:pt idx="8">
                    <c:v>2.02428587074189</c:v>
                  </c:pt>
                  <c:pt idx="9">
                    <c:v>2.31455999579667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bf4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cbf4'!$J$2:$J$11</c:f>
              <c:numCache>
                <c:formatCode>General</c:formatCode>
                <c:ptCount val="10"/>
                <c:pt idx="0">
                  <c:v>0.29864285714285699</c:v>
                </c:pt>
                <c:pt idx="1">
                  <c:v>0.48842857142857199</c:v>
                </c:pt>
                <c:pt idx="2">
                  <c:v>0.75614285714285701</c:v>
                </c:pt>
                <c:pt idx="3">
                  <c:v>1.12757142857143</c:v>
                </c:pt>
                <c:pt idx="4">
                  <c:v>2.0905714285714301</c:v>
                </c:pt>
                <c:pt idx="5">
                  <c:v>3.4158571428571398</c:v>
                </c:pt>
                <c:pt idx="6">
                  <c:v>5.4041428571428396</c:v>
                </c:pt>
                <c:pt idx="7">
                  <c:v>8.9290714285714294</c:v>
                </c:pt>
                <c:pt idx="8">
                  <c:v>12.57</c:v>
                </c:pt>
                <c:pt idx="9">
                  <c:v>17.0000714285713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BAE-4DE2-B693-33E59B726E70}"/>
            </c:ext>
          </c:extLst>
        </c:ser>
        <c:ser>
          <c:idx val="2"/>
          <c:order val="2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bf4'!$Q$2:$Q$11</c:f>
                <c:numCache>
                  <c:formatCode>General</c:formatCode>
                  <c:ptCount val="10"/>
                  <c:pt idx="0">
                    <c:v>2.7781150108014002E-2</c:v>
                  </c:pt>
                  <c:pt idx="1">
                    <c:v>4.4980140336108199E-2</c:v>
                  </c:pt>
                  <c:pt idx="2">
                    <c:v>8.2316311875418005E-2</c:v>
                  </c:pt>
                  <c:pt idx="3">
                    <c:v>0.166897978868916</c:v>
                  </c:pt>
                  <c:pt idx="4">
                    <c:v>0.32735731321580902</c:v>
                  </c:pt>
                  <c:pt idx="5">
                    <c:v>0.69534398140804698</c:v>
                  </c:pt>
                  <c:pt idx="6">
                    <c:v>1.0473884754818801</c:v>
                  </c:pt>
                  <c:pt idx="7">
                    <c:v>1.57478004734577</c:v>
                  </c:pt>
                  <c:pt idx="8">
                    <c:v>2.18647863795483</c:v>
                  </c:pt>
                  <c:pt idx="9">
                    <c:v>2.5000105272777202</c:v>
                  </c:pt>
                </c:numCache>
              </c:numRef>
            </c:plus>
            <c:minus>
              <c:numRef>
                <c:f>'cbf4'!$Q$2:$Q$11</c:f>
                <c:numCache>
                  <c:formatCode>General</c:formatCode>
                  <c:ptCount val="10"/>
                  <c:pt idx="0">
                    <c:v>2.7781150108014002E-2</c:v>
                  </c:pt>
                  <c:pt idx="1">
                    <c:v>4.4980140336108199E-2</c:v>
                  </c:pt>
                  <c:pt idx="2">
                    <c:v>8.2316311875418005E-2</c:v>
                  </c:pt>
                  <c:pt idx="3">
                    <c:v>0.166897978868916</c:v>
                  </c:pt>
                  <c:pt idx="4">
                    <c:v>0.32735731321580902</c:v>
                  </c:pt>
                  <c:pt idx="5">
                    <c:v>0.69534398140804698</c:v>
                  </c:pt>
                  <c:pt idx="6">
                    <c:v>1.0473884754818801</c:v>
                  </c:pt>
                  <c:pt idx="7">
                    <c:v>1.57478004734577</c:v>
                  </c:pt>
                  <c:pt idx="8">
                    <c:v>2.18647863795483</c:v>
                  </c:pt>
                  <c:pt idx="9">
                    <c:v>2.50001052727772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bf4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cbf4'!$K$2:$K$11</c:f>
              <c:numCache>
                <c:formatCode>General</c:formatCode>
                <c:ptCount val="10"/>
                <c:pt idx="0">
                  <c:v>0.29469515488607301</c:v>
                </c:pt>
                <c:pt idx="1">
                  <c:v>0.432</c:v>
                </c:pt>
                <c:pt idx="2">
                  <c:v>0.63575000000000004</c:v>
                </c:pt>
                <c:pt idx="3">
                  <c:v>1.2545833333333301</c:v>
                </c:pt>
                <c:pt idx="4">
                  <c:v>2.5197500000000002</c:v>
                </c:pt>
                <c:pt idx="5">
                  <c:v>4.7323333333333304</c:v>
                </c:pt>
                <c:pt idx="6">
                  <c:v>9.0260833333333306</c:v>
                </c:pt>
                <c:pt idx="7">
                  <c:v>13.49375</c:v>
                </c:pt>
                <c:pt idx="8">
                  <c:v>20.189499999999999</c:v>
                </c:pt>
                <c:pt idx="9">
                  <c:v>28.72674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BAE-4DE2-B693-33E59B726E70}"/>
            </c:ext>
          </c:extLst>
        </c:ser>
        <c:ser>
          <c:idx val="3"/>
          <c:order val="3"/>
          <c:spPr>
            <a:ln w="28575" cap="rnd">
              <a:solidFill>
                <a:schemeClr val="accent2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  <a:prstDash val="dash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bf4'!$R$2:$R$11</c:f>
                <c:numCache>
                  <c:formatCode>General</c:formatCode>
                  <c:ptCount val="10"/>
                  <c:pt idx="0">
                    <c:v>2.6666298731975398E-2</c:v>
                  </c:pt>
                  <c:pt idx="1">
                    <c:v>4.4980140336108199E-2</c:v>
                  </c:pt>
                  <c:pt idx="2">
                    <c:v>8.2316311875418005E-2</c:v>
                  </c:pt>
                  <c:pt idx="3">
                    <c:v>0.166897978868916</c:v>
                  </c:pt>
                  <c:pt idx="4">
                    <c:v>0.32735731321580902</c:v>
                  </c:pt>
                  <c:pt idx="5">
                    <c:v>0.69534398140804698</c:v>
                  </c:pt>
                  <c:pt idx="6">
                    <c:v>1.0473884754818801</c:v>
                  </c:pt>
                  <c:pt idx="7">
                    <c:v>1.57478004734577</c:v>
                  </c:pt>
                  <c:pt idx="8">
                    <c:v>2.18647863795483</c:v>
                  </c:pt>
                  <c:pt idx="9">
                    <c:v>2.5000105272777202</c:v>
                  </c:pt>
                </c:numCache>
              </c:numRef>
            </c:plus>
            <c:minus>
              <c:numRef>
                <c:f>'cbf4'!$R$2:$R$11</c:f>
                <c:numCache>
                  <c:formatCode>General</c:formatCode>
                  <c:ptCount val="10"/>
                  <c:pt idx="0">
                    <c:v>2.6666298731975398E-2</c:v>
                  </c:pt>
                  <c:pt idx="1">
                    <c:v>4.4980140336108199E-2</c:v>
                  </c:pt>
                  <c:pt idx="2">
                    <c:v>8.2316311875418005E-2</c:v>
                  </c:pt>
                  <c:pt idx="3">
                    <c:v>0.166897978868916</c:v>
                  </c:pt>
                  <c:pt idx="4">
                    <c:v>0.32735731321580902</c:v>
                  </c:pt>
                  <c:pt idx="5">
                    <c:v>0.69534398140804698</c:v>
                  </c:pt>
                  <c:pt idx="6">
                    <c:v>1.0473884754818801</c:v>
                  </c:pt>
                  <c:pt idx="7">
                    <c:v>1.57478004734577</c:v>
                  </c:pt>
                  <c:pt idx="8">
                    <c:v>2.18647863795483</c:v>
                  </c:pt>
                  <c:pt idx="9">
                    <c:v>2.50001052727772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bf4'!$H$2:$H$11</c:f>
              <c:strCache>
                <c:ptCount val="10"/>
                <c:pt idx="0">
                  <c:v>Day9</c:v>
                </c:pt>
                <c:pt idx="1">
                  <c:v>Day11</c:v>
                </c:pt>
                <c:pt idx="2">
                  <c:v>Day13</c:v>
                </c:pt>
                <c:pt idx="3">
                  <c:v>Day15</c:v>
                </c:pt>
                <c:pt idx="4">
                  <c:v>Day17</c:v>
                </c:pt>
                <c:pt idx="5">
                  <c:v>Day19</c:v>
                </c:pt>
                <c:pt idx="6">
                  <c:v>Day21</c:v>
                </c:pt>
                <c:pt idx="7">
                  <c:v>Day23</c:v>
                </c:pt>
                <c:pt idx="8">
                  <c:v>Day25</c:v>
                </c:pt>
                <c:pt idx="9">
                  <c:v>Day27</c:v>
                </c:pt>
              </c:strCache>
            </c:strRef>
          </c:cat>
          <c:val>
            <c:numRef>
              <c:f>'cbf4'!$L$2:$L$11</c:f>
              <c:numCache>
                <c:formatCode>General</c:formatCode>
                <c:ptCount val="10"/>
                <c:pt idx="0">
                  <c:v>0.41116666666666701</c:v>
                </c:pt>
                <c:pt idx="1">
                  <c:v>0.694583333333333</c:v>
                </c:pt>
                <c:pt idx="2">
                  <c:v>1.3472500000000001</c:v>
                </c:pt>
                <c:pt idx="3">
                  <c:v>2.3289166666666699</c:v>
                </c:pt>
                <c:pt idx="4">
                  <c:v>4.6217499999999996</c:v>
                </c:pt>
                <c:pt idx="5">
                  <c:v>8.6334166666666601</c:v>
                </c:pt>
                <c:pt idx="6">
                  <c:v>14.9561666666667</c:v>
                </c:pt>
                <c:pt idx="7">
                  <c:v>22.568666666666701</c:v>
                </c:pt>
                <c:pt idx="8">
                  <c:v>31.724416666666698</c:v>
                </c:pt>
                <c:pt idx="9">
                  <c:v>43.49116666666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BAE-4DE2-B693-33E59B726E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7969688"/>
        <c:axId val="507967392"/>
      </c:lineChart>
      <c:catAx>
        <c:axId val="507969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967392"/>
        <c:crosses val="autoZero"/>
        <c:auto val="1"/>
        <c:lblAlgn val="ctr"/>
        <c:lblOffset val="100"/>
        <c:noMultiLvlLbl val="0"/>
      </c:catAx>
      <c:valAx>
        <c:axId val="5079673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6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7969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8992868143718313E-2"/>
          <c:y val="5.5744222252619741E-2"/>
          <c:w val="0.85730312156753807"/>
          <c:h val="0.888511555494760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2!$E$59:$E$62</c:f>
                <c:numCache>
                  <c:formatCode>General</c:formatCode>
                  <c:ptCount val="4"/>
                  <c:pt idx="0">
                    <c:v>1.0137028480433601</c:v>
                  </c:pt>
                  <c:pt idx="1">
                    <c:v>1.0137028480433601</c:v>
                  </c:pt>
                  <c:pt idx="2">
                    <c:v>1.08818902221848</c:v>
                  </c:pt>
                  <c:pt idx="3">
                    <c:v>1.0492821342629699</c:v>
                  </c:pt>
                </c:numCache>
              </c:numRef>
            </c:plus>
            <c:minus>
              <c:numRef>
                <c:f>Sheet2!$E$59:$E$62</c:f>
                <c:numCache>
                  <c:formatCode>General</c:formatCode>
                  <c:ptCount val="4"/>
                  <c:pt idx="0">
                    <c:v>1.0137028480433601</c:v>
                  </c:pt>
                  <c:pt idx="1">
                    <c:v>1.0137028480433601</c:v>
                  </c:pt>
                  <c:pt idx="2">
                    <c:v>1.08818902221848</c:v>
                  </c:pt>
                  <c:pt idx="3">
                    <c:v>1.0492821342629699</c:v>
                  </c:pt>
                </c:numCache>
              </c:numRef>
            </c:minus>
          </c:errBars>
          <c:val>
            <c:numRef>
              <c:f>Sheet2!$D$59:$D$62</c:f>
              <c:numCache>
                <c:formatCode>General</c:formatCode>
                <c:ptCount val="4"/>
                <c:pt idx="0">
                  <c:v>46</c:v>
                </c:pt>
                <c:pt idx="1">
                  <c:v>37.799999999999997</c:v>
                </c:pt>
                <c:pt idx="2">
                  <c:v>34.348435496385697</c:v>
                </c:pt>
                <c:pt idx="3">
                  <c:v>3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86-4EE7-BE93-2FED8D7D50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227127680"/>
        <c:axId val="227129216"/>
      </c:barChart>
      <c:catAx>
        <c:axId val="227127680"/>
        <c:scaling>
          <c:orientation val="minMax"/>
        </c:scaling>
        <c:delete val="0"/>
        <c:axPos val="b"/>
        <c:majorTickMark val="out"/>
        <c:minorTickMark val="none"/>
        <c:tickLblPos val="none"/>
        <c:crossAx val="227129216"/>
        <c:crosses val="autoZero"/>
        <c:auto val="1"/>
        <c:lblAlgn val="ctr"/>
        <c:lblOffset val="100"/>
        <c:noMultiLvlLbl val="0"/>
      </c:catAx>
      <c:valAx>
        <c:axId val="2271292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crossAx val="227127680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303171456360584"/>
          <c:y val="5.42170041338918E-2"/>
          <c:w val="0.8572119946294573"/>
          <c:h val="0.891565991732216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2!$K$59:$K$62</c:f>
                <c:numCache>
                  <c:formatCode>General</c:formatCode>
                  <c:ptCount val="4"/>
                  <c:pt idx="0">
                    <c:v>1.55477512209069</c:v>
                  </c:pt>
                  <c:pt idx="1">
                    <c:v>1.1874791142691301</c:v>
                  </c:pt>
                  <c:pt idx="2">
                    <c:v>1.55477512209069</c:v>
                  </c:pt>
                  <c:pt idx="3">
                    <c:v>1.3008181949029101</c:v>
                  </c:pt>
                </c:numCache>
              </c:numRef>
            </c:plus>
            <c:minus>
              <c:numRef>
                <c:f>Sheet2!$K$59:$K$62</c:f>
                <c:numCache>
                  <c:formatCode>General</c:formatCode>
                  <c:ptCount val="4"/>
                  <c:pt idx="0">
                    <c:v>1.55477512209069</c:v>
                  </c:pt>
                  <c:pt idx="1">
                    <c:v>1.1874791142691301</c:v>
                  </c:pt>
                  <c:pt idx="2">
                    <c:v>1.55477512209069</c:v>
                  </c:pt>
                  <c:pt idx="3">
                    <c:v>1.3008181949029101</c:v>
                  </c:pt>
                </c:numCache>
              </c:numRef>
            </c:minus>
          </c:errBars>
          <c:val>
            <c:numRef>
              <c:f>Sheet2!$J$59:$J$62</c:f>
              <c:numCache>
                <c:formatCode>General</c:formatCode>
                <c:ptCount val="4"/>
                <c:pt idx="0">
                  <c:v>47.857142857142897</c:v>
                </c:pt>
                <c:pt idx="1">
                  <c:v>56.8333333333333</c:v>
                </c:pt>
                <c:pt idx="2">
                  <c:v>34.142857142857103</c:v>
                </c:pt>
                <c:pt idx="3">
                  <c:v>31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02-48FF-B295-39C7D9A06E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193897984"/>
        <c:axId val="193899520"/>
      </c:barChart>
      <c:catAx>
        <c:axId val="193897984"/>
        <c:scaling>
          <c:orientation val="minMax"/>
        </c:scaling>
        <c:delete val="0"/>
        <c:axPos val="b"/>
        <c:majorTickMark val="out"/>
        <c:minorTickMark val="none"/>
        <c:tickLblPos val="none"/>
        <c:crossAx val="193899520"/>
        <c:crosses val="autoZero"/>
        <c:auto val="1"/>
        <c:lblAlgn val="ctr"/>
        <c:lblOffset val="100"/>
        <c:noMultiLvlLbl val="0"/>
      </c:catAx>
      <c:valAx>
        <c:axId val="1938995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crossAx val="1938979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303174681683488"/>
          <c:y val="5.5578329646558372E-2"/>
          <c:w val="0.85721194993084904"/>
          <c:h val="0.8888433407068833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2!$BA$59:$BA$62</c:f>
                <c:numCache>
                  <c:formatCode>General</c:formatCode>
                  <c:ptCount val="4"/>
                  <c:pt idx="0">
                    <c:v>0.99863041848968104</c:v>
                  </c:pt>
                  <c:pt idx="1">
                    <c:v>0.99863041848968104</c:v>
                  </c:pt>
                  <c:pt idx="2">
                    <c:v>1.12243496259507</c:v>
                  </c:pt>
                  <c:pt idx="3">
                    <c:v>1.0987323411635499</c:v>
                  </c:pt>
                </c:numCache>
              </c:numRef>
            </c:plus>
            <c:minus>
              <c:numRef>
                <c:f>Sheet2!$BA$59:$BA$62</c:f>
                <c:numCache>
                  <c:formatCode>General</c:formatCode>
                  <c:ptCount val="4"/>
                  <c:pt idx="0">
                    <c:v>0.99863041848968104</c:v>
                  </c:pt>
                  <c:pt idx="1">
                    <c:v>0.99863041848968104</c:v>
                  </c:pt>
                  <c:pt idx="2">
                    <c:v>1.12243496259507</c:v>
                  </c:pt>
                  <c:pt idx="3">
                    <c:v>1.0987323411635499</c:v>
                  </c:pt>
                </c:numCache>
              </c:numRef>
            </c:minus>
          </c:errBars>
          <c:val>
            <c:numRef>
              <c:f>Sheet2!$AZ$59:$AZ$62</c:f>
              <c:numCache>
                <c:formatCode>General</c:formatCode>
                <c:ptCount val="4"/>
                <c:pt idx="0">
                  <c:v>45.043478260869598</c:v>
                </c:pt>
                <c:pt idx="1">
                  <c:v>49.956521739130402</c:v>
                </c:pt>
                <c:pt idx="2">
                  <c:v>33.529860542168997</c:v>
                </c:pt>
                <c:pt idx="3">
                  <c:v>35.6842105263158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40-49C7-A572-1106410F6C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194714240"/>
        <c:axId val="194720128"/>
      </c:barChart>
      <c:catAx>
        <c:axId val="194714240"/>
        <c:scaling>
          <c:orientation val="minMax"/>
        </c:scaling>
        <c:delete val="0"/>
        <c:axPos val="b"/>
        <c:majorTickMark val="out"/>
        <c:minorTickMark val="none"/>
        <c:tickLblPos val="none"/>
        <c:crossAx val="194720128"/>
        <c:crosses val="autoZero"/>
        <c:auto val="1"/>
        <c:lblAlgn val="ctr"/>
        <c:lblOffset val="100"/>
        <c:noMultiLvlLbl val="0"/>
      </c:catAx>
      <c:valAx>
        <c:axId val="1947201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crossAx val="1947142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00391B-6861-4074-BD8F-72FC725DBC1E}" type="datetimeFigureOut">
              <a:rPr lang="en-US" smtClean="0"/>
              <a:t>3/1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A414DF-FF05-45FC-9AC4-BDD6151FC0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1958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A414DF-FF05-45FC-9AC4-BDD6151FC02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9013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A414DF-FF05-45FC-9AC4-BDD6151FC02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14215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A414DF-FF05-45FC-9AC4-BDD6151FC02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4662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 rot="16200000">
            <a:off x="1523353" y="8626572"/>
            <a:ext cx="369332" cy="29591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ilr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837112" y="8545619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2905593" y="8626572"/>
            <a:ext cx="369332" cy="29591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ilr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2207477" y="8545620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1520846" y="2435614"/>
            <a:ext cx="369332" cy="3824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bf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834605" y="2397943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2903086" y="2435614"/>
            <a:ext cx="369332" cy="3824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bf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2204970" y="2397943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41" name="TextBox 2"/>
          <p:cNvSpPr txBox="1"/>
          <p:nvPr/>
        </p:nvSpPr>
        <p:spPr>
          <a:xfrm rot="10800000">
            <a:off x="43856" y="733297"/>
            <a:ext cx="553998" cy="113268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nt Size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78333" y="633170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66544" y="16767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66544" y="304106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47" name="内容占位符 3">
            <a:extLst>
              <a:ext uri="{FF2B5EF4-FFF2-40B4-BE49-F238E27FC236}">
                <a16:creationId xmlns:a16="http://schemas.microsoft.com/office/drawing/2014/main" id="{2BDE2710-219C-4A39-9F22-5CD6257D9EDB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12283" y="64394"/>
          <a:ext cx="3136837" cy="25369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8" name="内容占位符 12">
            <a:extLst>
              <a:ext uri="{FF2B5EF4-FFF2-40B4-BE49-F238E27FC236}">
                <a16:creationId xmlns:a16="http://schemas.microsoft.com/office/drawing/2014/main" id="{515D3AB8-55CF-4485-BABD-9934298BDE4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29522604"/>
              </p:ext>
            </p:extLst>
          </p:nvPr>
        </p:nvGraphicFramePr>
        <p:xfrm>
          <a:off x="551329" y="6191582"/>
          <a:ext cx="3020471" cy="25369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3" name="内容占位符 14">
            <a:extLst>
              <a:ext uri="{FF2B5EF4-FFF2-40B4-BE49-F238E27FC236}">
                <a16:creationId xmlns:a16="http://schemas.microsoft.com/office/drawing/2014/main" id="{FAA55BC2-4FE0-42EC-9B19-C6D1844990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1833913"/>
              </p:ext>
            </p:extLst>
          </p:nvPr>
        </p:nvGraphicFramePr>
        <p:xfrm>
          <a:off x="356322" y="2949693"/>
          <a:ext cx="3194461" cy="25369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4" name="TextBox 23">
            <a:extLst>
              <a:ext uri="{FF2B5EF4-FFF2-40B4-BE49-F238E27FC236}">
                <a16:creationId xmlns:a16="http://schemas.microsoft.com/office/drawing/2014/main" id="{D0838816-86C6-48F5-B418-819E1972663A}"/>
              </a:ext>
            </a:extLst>
          </p:cNvPr>
          <p:cNvSpPr txBox="1"/>
          <p:nvPr/>
        </p:nvSpPr>
        <p:spPr>
          <a:xfrm rot="16200000">
            <a:off x="1484238" y="5334310"/>
            <a:ext cx="369332" cy="39049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bf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24">
            <a:extLst>
              <a:ext uri="{FF2B5EF4-FFF2-40B4-BE49-F238E27FC236}">
                <a16:creationId xmlns:a16="http://schemas.microsoft.com/office/drawing/2014/main" id="{2189EFF3-BD3D-41A0-B926-273B64C52D82}"/>
              </a:ext>
            </a:extLst>
          </p:cNvPr>
          <p:cNvSpPr txBox="1"/>
          <p:nvPr/>
        </p:nvSpPr>
        <p:spPr>
          <a:xfrm rot="16200000">
            <a:off x="818013" y="5300647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56" name="TextBox 25">
            <a:extLst>
              <a:ext uri="{FF2B5EF4-FFF2-40B4-BE49-F238E27FC236}">
                <a16:creationId xmlns:a16="http://schemas.microsoft.com/office/drawing/2014/main" id="{EAE032FC-C96E-4372-B634-E6AA2F356F74}"/>
              </a:ext>
            </a:extLst>
          </p:cNvPr>
          <p:cNvSpPr txBox="1"/>
          <p:nvPr/>
        </p:nvSpPr>
        <p:spPr>
          <a:xfrm rot="16200000">
            <a:off x="2878353" y="5334310"/>
            <a:ext cx="369332" cy="39049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bf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26">
            <a:extLst>
              <a:ext uri="{FF2B5EF4-FFF2-40B4-BE49-F238E27FC236}">
                <a16:creationId xmlns:a16="http://schemas.microsoft.com/office/drawing/2014/main" id="{F46ED0BE-8429-404D-8637-8F2E962A4873}"/>
              </a:ext>
            </a:extLst>
          </p:cNvPr>
          <p:cNvSpPr txBox="1"/>
          <p:nvPr/>
        </p:nvSpPr>
        <p:spPr>
          <a:xfrm rot="16200000">
            <a:off x="2180237" y="5300647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cxnSp>
        <p:nvCxnSpPr>
          <p:cNvPr id="58" name="Straight Connector 36">
            <a:extLst>
              <a:ext uri="{FF2B5EF4-FFF2-40B4-BE49-F238E27FC236}">
                <a16:creationId xmlns:a16="http://schemas.microsoft.com/office/drawing/2014/main" id="{D05D8693-4E7B-45DC-80F5-3F9AC527681F}"/>
              </a:ext>
            </a:extLst>
          </p:cNvPr>
          <p:cNvCxnSpPr/>
          <p:nvPr/>
        </p:nvCxnSpPr>
        <p:spPr>
          <a:xfrm>
            <a:off x="951878" y="5680675"/>
            <a:ext cx="849404" cy="0"/>
          </a:xfrm>
          <a:prstGeom prst="line">
            <a:avLst/>
          </a:prstGeom>
          <a:ln w="9525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38">
            <a:extLst>
              <a:ext uri="{FF2B5EF4-FFF2-40B4-BE49-F238E27FC236}">
                <a16:creationId xmlns:a16="http://schemas.microsoft.com/office/drawing/2014/main" id="{2B76DC7A-D0A0-42F9-9B06-38D9D8733F31}"/>
              </a:ext>
            </a:extLst>
          </p:cNvPr>
          <p:cNvSpPr txBox="1"/>
          <p:nvPr/>
        </p:nvSpPr>
        <p:spPr>
          <a:xfrm>
            <a:off x="877687" y="5711238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ean CEF</a:t>
            </a:r>
          </a:p>
        </p:txBody>
      </p:sp>
      <p:sp>
        <p:nvSpPr>
          <p:cNvPr id="60" name="TextBox 39">
            <a:extLst>
              <a:ext uri="{FF2B5EF4-FFF2-40B4-BE49-F238E27FC236}">
                <a16:creationId xmlns:a16="http://schemas.microsoft.com/office/drawing/2014/main" id="{AC7350AA-4913-4C6B-B22B-4CBB05CEB1BC}"/>
              </a:ext>
            </a:extLst>
          </p:cNvPr>
          <p:cNvSpPr txBox="1"/>
          <p:nvPr/>
        </p:nvSpPr>
        <p:spPr>
          <a:xfrm>
            <a:off x="2231840" y="5711238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ress LSA</a:t>
            </a:r>
          </a:p>
        </p:txBody>
      </p:sp>
      <p:cxnSp>
        <p:nvCxnSpPr>
          <p:cNvPr id="61" name="Straight Connector 48">
            <a:extLst>
              <a:ext uri="{FF2B5EF4-FFF2-40B4-BE49-F238E27FC236}">
                <a16:creationId xmlns:a16="http://schemas.microsoft.com/office/drawing/2014/main" id="{43E23126-7601-4848-B2C4-E74D1E9AC4DD}"/>
              </a:ext>
            </a:extLst>
          </p:cNvPr>
          <p:cNvCxnSpPr/>
          <p:nvPr/>
        </p:nvCxnSpPr>
        <p:spPr>
          <a:xfrm>
            <a:off x="2272724" y="5680675"/>
            <a:ext cx="849404" cy="0"/>
          </a:xfrm>
          <a:prstGeom prst="line">
            <a:avLst/>
          </a:prstGeom>
          <a:ln w="9525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19">
            <a:extLst>
              <a:ext uri="{FF2B5EF4-FFF2-40B4-BE49-F238E27FC236}">
                <a16:creationId xmlns:a16="http://schemas.microsoft.com/office/drawing/2014/main" id="{2950D160-EB5D-40E0-93C8-C3E1718F0F81}"/>
              </a:ext>
            </a:extLst>
          </p:cNvPr>
          <p:cNvSpPr txBox="1"/>
          <p:nvPr/>
        </p:nvSpPr>
        <p:spPr>
          <a:xfrm>
            <a:off x="900201" y="3619276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3" name="TextBox 19">
            <a:extLst>
              <a:ext uri="{FF2B5EF4-FFF2-40B4-BE49-F238E27FC236}">
                <a16:creationId xmlns:a16="http://schemas.microsoft.com/office/drawing/2014/main" id="{DB5288EF-405B-4C2A-A2D6-31ACF243F53E}"/>
              </a:ext>
            </a:extLst>
          </p:cNvPr>
          <p:cNvSpPr txBox="1"/>
          <p:nvPr/>
        </p:nvSpPr>
        <p:spPr>
          <a:xfrm>
            <a:off x="2955800" y="3593091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4" name="TextBox 19">
            <a:extLst>
              <a:ext uri="{FF2B5EF4-FFF2-40B4-BE49-F238E27FC236}">
                <a16:creationId xmlns:a16="http://schemas.microsoft.com/office/drawing/2014/main" id="{226A0A72-49DC-4C0F-B8BF-56A374253110}"/>
              </a:ext>
            </a:extLst>
          </p:cNvPr>
          <p:cNvSpPr txBox="1"/>
          <p:nvPr/>
        </p:nvSpPr>
        <p:spPr>
          <a:xfrm>
            <a:off x="2271728" y="314989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5" name="TextBox 19">
            <a:extLst>
              <a:ext uri="{FF2B5EF4-FFF2-40B4-BE49-F238E27FC236}">
                <a16:creationId xmlns:a16="http://schemas.microsoft.com/office/drawing/2014/main" id="{EB653A90-04D7-4B94-9BF6-CCC2F49ED5D2}"/>
              </a:ext>
            </a:extLst>
          </p:cNvPr>
          <p:cNvSpPr txBox="1"/>
          <p:nvPr/>
        </p:nvSpPr>
        <p:spPr>
          <a:xfrm>
            <a:off x="1586473" y="4003235"/>
            <a:ext cx="316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19">
            <a:extLst>
              <a:ext uri="{FF2B5EF4-FFF2-40B4-BE49-F238E27FC236}">
                <a16:creationId xmlns:a16="http://schemas.microsoft.com/office/drawing/2014/main" id="{26173B9C-A736-4953-B2AA-8BAD25E0F78E}"/>
              </a:ext>
            </a:extLst>
          </p:cNvPr>
          <p:cNvSpPr txBox="1"/>
          <p:nvPr/>
        </p:nvSpPr>
        <p:spPr>
          <a:xfrm>
            <a:off x="904551" y="131419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7" name="TextBox 19">
            <a:extLst>
              <a:ext uri="{FF2B5EF4-FFF2-40B4-BE49-F238E27FC236}">
                <a16:creationId xmlns:a16="http://schemas.microsoft.com/office/drawing/2014/main" id="{FF60B615-CA98-41DE-A679-707D1DFB0EAF}"/>
              </a:ext>
            </a:extLst>
          </p:cNvPr>
          <p:cNvSpPr txBox="1"/>
          <p:nvPr/>
        </p:nvSpPr>
        <p:spPr>
          <a:xfrm>
            <a:off x="2960150" y="29661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8" name="TextBox 19">
            <a:extLst>
              <a:ext uri="{FF2B5EF4-FFF2-40B4-BE49-F238E27FC236}">
                <a16:creationId xmlns:a16="http://schemas.microsoft.com/office/drawing/2014/main" id="{1784D14F-769C-483C-90A5-1CFAF3306422}"/>
              </a:ext>
            </a:extLst>
          </p:cNvPr>
          <p:cNvSpPr txBox="1"/>
          <p:nvPr/>
        </p:nvSpPr>
        <p:spPr>
          <a:xfrm>
            <a:off x="2267369" y="1112371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9" name="TextBox 19">
            <a:extLst>
              <a:ext uri="{FF2B5EF4-FFF2-40B4-BE49-F238E27FC236}">
                <a16:creationId xmlns:a16="http://schemas.microsoft.com/office/drawing/2014/main" id="{F13BAE98-B3BF-45C6-9CAD-F9709C4CCD2F}"/>
              </a:ext>
            </a:extLst>
          </p:cNvPr>
          <p:cNvSpPr txBox="1"/>
          <p:nvPr/>
        </p:nvSpPr>
        <p:spPr>
          <a:xfrm>
            <a:off x="1549109" y="1212200"/>
            <a:ext cx="3932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19">
            <a:extLst>
              <a:ext uri="{FF2B5EF4-FFF2-40B4-BE49-F238E27FC236}">
                <a16:creationId xmlns:a16="http://schemas.microsoft.com/office/drawing/2014/main" id="{99F97304-A608-4955-B826-94D18D874387}"/>
              </a:ext>
            </a:extLst>
          </p:cNvPr>
          <p:cNvSpPr txBox="1"/>
          <p:nvPr/>
        </p:nvSpPr>
        <p:spPr>
          <a:xfrm>
            <a:off x="865357" y="7331365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19">
            <a:extLst>
              <a:ext uri="{FF2B5EF4-FFF2-40B4-BE49-F238E27FC236}">
                <a16:creationId xmlns:a16="http://schemas.microsoft.com/office/drawing/2014/main" id="{EDDC1B1B-33BA-4048-898E-4134A047C0E3}"/>
              </a:ext>
            </a:extLst>
          </p:cNvPr>
          <p:cNvSpPr txBox="1"/>
          <p:nvPr/>
        </p:nvSpPr>
        <p:spPr>
          <a:xfrm>
            <a:off x="2959115" y="624411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2" name="TextBox 19">
            <a:extLst>
              <a:ext uri="{FF2B5EF4-FFF2-40B4-BE49-F238E27FC236}">
                <a16:creationId xmlns:a16="http://schemas.microsoft.com/office/drawing/2014/main" id="{4E5F500C-0803-4011-813D-3A79544EF793}"/>
              </a:ext>
            </a:extLst>
          </p:cNvPr>
          <p:cNvSpPr txBox="1"/>
          <p:nvPr/>
        </p:nvSpPr>
        <p:spPr>
          <a:xfrm>
            <a:off x="2263011" y="7077286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3" name="TextBox 19">
            <a:extLst>
              <a:ext uri="{FF2B5EF4-FFF2-40B4-BE49-F238E27FC236}">
                <a16:creationId xmlns:a16="http://schemas.microsoft.com/office/drawing/2014/main" id="{AF0C55E1-365C-418E-A017-19954D509E02}"/>
              </a:ext>
            </a:extLst>
          </p:cNvPr>
          <p:cNvSpPr txBox="1"/>
          <p:nvPr/>
        </p:nvSpPr>
        <p:spPr>
          <a:xfrm>
            <a:off x="1588296" y="7551584"/>
            <a:ext cx="3932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9">
            <a:extLst>
              <a:ext uri="{FF2B5EF4-FFF2-40B4-BE49-F238E27FC236}">
                <a16:creationId xmlns:a16="http://schemas.microsoft.com/office/drawing/2014/main" id="{E32EC7B2-B6DF-46B3-AC42-364DA4798C31}"/>
              </a:ext>
            </a:extLst>
          </p:cNvPr>
          <p:cNvSpPr txBox="1"/>
          <p:nvPr/>
        </p:nvSpPr>
        <p:spPr>
          <a:xfrm>
            <a:off x="323994" y="8504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.0</a:t>
            </a:r>
          </a:p>
        </p:txBody>
      </p:sp>
      <p:sp>
        <p:nvSpPr>
          <p:cNvPr id="50" name="TextBox 19">
            <a:extLst>
              <a:ext uri="{FF2B5EF4-FFF2-40B4-BE49-F238E27FC236}">
                <a16:creationId xmlns:a16="http://schemas.microsoft.com/office/drawing/2014/main" id="{E91A8AC1-2F97-4845-A898-0A9459132F38}"/>
              </a:ext>
            </a:extLst>
          </p:cNvPr>
          <p:cNvSpPr txBox="1"/>
          <p:nvPr/>
        </p:nvSpPr>
        <p:spPr>
          <a:xfrm>
            <a:off x="323994" y="46144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51" name="TextBox 19">
            <a:extLst>
              <a:ext uri="{FF2B5EF4-FFF2-40B4-BE49-F238E27FC236}">
                <a16:creationId xmlns:a16="http://schemas.microsoft.com/office/drawing/2014/main" id="{7809CE8B-AA22-4508-93B9-D145181293E0}"/>
              </a:ext>
            </a:extLst>
          </p:cNvPr>
          <p:cNvSpPr txBox="1"/>
          <p:nvPr/>
        </p:nvSpPr>
        <p:spPr>
          <a:xfrm>
            <a:off x="323994" y="83217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52" name="TextBox 19">
            <a:extLst>
              <a:ext uri="{FF2B5EF4-FFF2-40B4-BE49-F238E27FC236}">
                <a16:creationId xmlns:a16="http://schemas.microsoft.com/office/drawing/2014/main" id="{04C71ACC-BF0F-486B-BC0D-13CC8B293095}"/>
              </a:ext>
            </a:extLst>
          </p:cNvPr>
          <p:cNvSpPr txBox="1"/>
          <p:nvPr/>
        </p:nvSpPr>
        <p:spPr>
          <a:xfrm>
            <a:off x="323994" y="121059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76" name="TextBox 19">
            <a:extLst>
              <a:ext uri="{FF2B5EF4-FFF2-40B4-BE49-F238E27FC236}">
                <a16:creationId xmlns:a16="http://schemas.microsoft.com/office/drawing/2014/main" id="{66547BC9-8E19-4367-9F25-1F6231889005}"/>
              </a:ext>
            </a:extLst>
          </p:cNvPr>
          <p:cNvSpPr txBox="1"/>
          <p:nvPr/>
        </p:nvSpPr>
        <p:spPr>
          <a:xfrm>
            <a:off x="323994" y="157710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77" name="TextBox 19">
            <a:extLst>
              <a:ext uri="{FF2B5EF4-FFF2-40B4-BE49-F238E27FC236}">
                <a16:creationId xmlns:a16="http://schemas.microsoft.com/office/drawing/2014/main" id="{6EC00E45-F754-48B4-A958-29C64287DCF5}"/>
              </a:ext>
            </a:extLst>
          </p:cNvPr>
          <p:cNvSpPr txBox="1"/>
          <p:nvPr/>
        </p:nvSpPr>
        <p:spPr>
          <a:xfrm>
            <a:off x="323994" y="195815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78" name="TextBox 19">
            <a:extLst>
              <a:ext uri="{FF2B5EF4-FFF2-40B4-BE49-F238E27FC236}">
                <a16:creationId xmlns:a16="http://schemas.microsoft.com/office/drawing/2014/main" id="{5E53CCCB-A8F8-4A27-B5FF-D1B71F32654A}"/>
              </a:ext>
            </a:extLst>
          </p:cNvPr>
          <p:cNvSpPr txBox="1"/>
          <p:nvPr/>
        </p:nvSpPr>
        <p:spPr>
          <a:xfrm>
            <a:off x="315656" y="2325183"/>
            <a:ext cx="369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80" name="TextBox 19">
            <a:extLst>
              <a:ext uri="{FF2B5EF4-FFF2-40B4-BE49-F238E27FC236}">
                <a16:creationId xmlns:a16="http://schemas.microsoft.com/office/drawing/2014/main" id="{B5A9EF8D-3487-4E3C-95AB-7DC9BBE02965}"/>
              </a:ext>
            </a:extLst>
          </p:cNvPr>
          <p:cNvSpPr txBox="1"/>
          <p:nvPr/>
        </p:nvSpPr>
        <p:spPr>
          <a:xfrm>
            <a:off x="323994" y="620272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81" name="TextBox 19">
            <a:extLst>
              <a:ext uri="{FF2B5EF4-FFF2-40B4-BE49-F238E27FC236}">
                <a16:creationId xmlns:a16="http://schemas.microsoft.com/office/drawing/2014/main" id="{E6B0A729-98B4-4799-B574-B85860AB8ADF}"/>
              </a:ext>
            </a:extLst>
          </p:cNvPr>
          <p:cNvSpPr txBox="1"/>
          <p:nvPr/>
        </p:nvSpPr>
        <p:spPr>
          <a:xfrm>
            <a:off x="323994" y="665383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82" name="TextBox 19">
            <a:extLst>
              <a:ext uri="{FF2B5EF4-FFF2-40B4-BE49-F238E27FC236}">
                <a16:creationId xmlns:a16="http://schemas.microsoft.com/office/drawing/2014/main" id="{C97193C3-484C-42DF-AA92-2F068615EE15}"/>
              </a:ext>
            </a:extLst>
          </p:cNvPr>
          <p:cNvSpPr txBox="1"/>
          <p:nvPr/>
        </p:nvSpPr>
        <p:spPr>
          <a:xfrm>
            <a:off x="323994" y="710651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83" name="TextBox 19">
            <a:extLst>
              <a:ext uri="{FF2B5EF4-FFF2-40B4-BE49-F238E27FC236}">
                <a16:creationId xmlns:a16="http://schemas.microsoft.com/office/drawing/2014/main" id="{B50B3CFD-35B5-456C-B30D-C95AC0B3F806}"/>
              </a:ext>
            </a:extLst>
          </p:cNvPr>
          <p:cNvSpPr txBox="1"/>
          <p:nvPr/>
        </p:nvSpPr>
        <p:spPr>
          <a:xfrm>
            <a:off x="323994" y="754668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84" name="TextBox 19">
            <a:extLst>
              <a:ext uri="{FF2B5EF4-FFF2-40B4-BE49-F238E27FC236}">
                <a16:creationId xmlns:a16="http://schemas.microsoft.com/office/drawing/2014/main" id="{EF75606F-ED4E-4E8F-A0D3-2694A856C49C}"/>
              </a:ext>
            </a:extLst>
          </p:cNvPr>
          <p:cNvSpPr txBox="1"/>
          <p:nvPr/>
        </p:nvSpPr>
        <p:spPr>
          <a:xfrm>
            <a:off x="323994" y="800169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85" name="TextBox 19">
            <a:extLst>
              <a:ext uri="{FF2B5EF4-FFF2-40B4-BE49-F238E27FC236}">
                <a16:creationId xmlns:a16="http://schemas.microsoft.com/office/drawing/2014/main" id="{78DEA432-7E6F-4207-8370-BE97CD9FAA7B}"/>
              </a:ext>
            </a:extLst>
          </p:cNvPr>
          <p:cNvSpPr txBox="1"/>
          <p:nvPr/>
        </p:nvSpPr>
        <p:spPr>
          <a:xfrm>
            <a:off x="315656" y="8462850"/>
            <a:ext cx="369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87" name="TextBox 19">
            <a:extLst>
              <a:ext uri="{FF2B5EF4-FFF2-40B4-BE49-F238E27FC236}">
                <a16:creationId xmlns:a16="http://schemas.microsoft.com/office/drawing/2014/main" id="{3CB6E55B-6545-477A-98A0-4C2EDD0E8621}"/>
              </a:ext>
            </a:extLst>
          </p:cNvPr>
          <p:cNvSpPr txBox="1"/>
          <p:nvPr/>
        </p:nvSpPr>
        <p:spPr>
          <a:xfrm>
            <a:off x="323994" y="296724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88" name="TextBox 19">
            <a:extLst>
              <a:ext uri="{FF2B5EF4-FFF2-40B4-BE49-F238E27FC236}">
                <a16:creationId xmlns:a16="http://schemas.microsoft.com/office/drawing/2014/main" id="{B80E93A4-61D7-4132-85F1-A7B7C8FEFE0E}"/>
              </a:ext>
            </a:extLst>
          </p:cNvPr>
          <p:cNvSpPr txBox="1"/>
          <p:nvPr/>
        </p:nvSpPr>
        <p:spPr>
          <a:xfrm>
            <a:off x="323994" y="352718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89" name="TextBox 19">
            <a:extLst>
              <a:ext uri="{FF2B5EF4-FFF2-40B4-BE49-F238E27FC236}">
                <a16:creationId xmlns:a16="http://schemas.microsoft.com/office/drawing/2014/main" id="{BAE05407-F7DC-4256-BEFE-9742DF68AFA8}"/>
              </a:ext>
            </a:extLst>
          </p:cNvPr>
          <p:cNvSpPr txBox="1"/>
          <p:nvPr/>
        </p:nvSpPr>
        <p:spPr>
          <a:xfrm>
            <a:off x="323994" y="4088376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90" name="TextBox 19">
            <a:extLst>
              <a:ext uri="{FF2B5EF4-FFF2-40B4-BE49-F238E27FC236}">
                <a16:creationId xmlns:a16="http://schemas.microsoft.com/office/drawing/2014/main" id="{8D0A857A-72AA-4CCE-B6C6-B121E9C6EE7B}"/>
              </a:ext>
            </a:extLst>
          </p:cNvPr>
          <p:cNvSpPr txBox="1"/>
          <p:nvPr/>
        </p:nvSpPr>
        <p:spPr>
          <a:xfrm>
            <a:off x="323994" y="465158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91" name="TextBox 19">
            <a:extLst>
              <a:ext uri="{FF2B5EF4-FFF2-40B4-BE49-F238E27FC236}">
                <a16:creationId xmlns:a16="http://schemas.microsoft.com/office/drawing/2014/main" id="{035B0C79-BB6B-46AF-A4D0-478CA8E949E7}"/>
              </a:ext>
            </a:extLst>
          </p:cNvPr>
          <p:cNvSpPr txBox="1"/>
          <p:nvPr/>
        </p:nvSpPr>
        <p:spPr>
          <a:xfrm>
            <a:off x="315656" y="5214220"/>
            <a:ext cx="369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79" name="TextBox 2">
            <a:extLst>
              <a:ext uri="{FF2B5EF4-FFF2-40B4-BE49-F238E27FC236}">
                <a16:creationId xmlns:a16="http://schemas.microsoft.com/office/drawing/2014/main" id="{0E3F68BC-4B6C-43FC-B58D-600A3412C3AA}"/>
              </a:ext>
            </a:extLst>
          </p:cNvPr>
          <p:cNvSpPr txBox="1"/>
          <p:nvPr/>
        </p:nvSpPr>
        <p:spPr>
          <a:xfrm rot="10800000">
            <a:off x="43856" y="3619951"/>
            <a:ext cx="553998" cy="113268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nt Size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2">
            <a:extLst>
              <a:ext uri="{FF2B5EF4-FFF2-40B4-BE49-F238E27FC236}">
                <a16:creationId xmlns:a16="http://schemas.microsoft.com/office/drawing/2014/main" id="{3EAE9413-3FC5-4637-AF8C-33FFE658F697}"/>
              </a:ext>
            </a:extLst>
          </p:cNvPr>
          <p:cNvSpPr txBox="1"/>
          <p:nvPr/>
        </p:nvSpPr>
        <p:spPr>
          <a:xfrm rot="10800000">
            <a:off x="43856" y="6816800"/>
            <a:ext cx="553998" cy="113268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nt Size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2734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7" name="内容占位符 3">
            <a:extLst>
              <a:ext uri="{FF2B5EF4-FFF2-40B4-BE49-F238E27FC236}">
                <a16:creationId xmlns:a16="http://schemas.microsoft.com/office/drawing/2014/main" id="{79534762-C775-4446-BF23-D55F842CF4A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47719625"/>
              </p:ext>
            </p:extLst>
          </p:nvPr>
        </p:nvGraphicFramePr>
        <p:xfrm>
          <a:off x="215620" y="5751595"/>
          <a:ext cx="6708276" cy="28234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0" name="内容占位符 7">
            <a:extLst>
              <a:ext uri="{FF2B5EF4-FFF2-40B4-BE49-F238E27FC236}">
                <a16:creationId xmlns:a16="http://schemas.microsoft.com/office/drawing/2014/main" id="{BBCE95BB-B99E-4899-8880-7ABA06DC71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3050854"/>
              </p:ext>
            </p:extLst>
          </p:nvPr>
        </p:nvGraphicFramePr>
        <p:xfrm>
          <a:off x="215619" y="2846650"/>
          <a:ext cx="6708276" cy="30051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2" name="TextBox 103">
            <a:extLst>
              <a:ext uri="{FF2B5EF4-FFF2-40B4-BE49-F238E27FC236}">
                <a16:creationId xmlns:a16="http://schemas.microsoft.com/office/drawing/2014/main" id="{49D1AEE9-530F-4C44-8F62-65A41EB8C03B}"/>
              </a:ext>
            </a:extLst>
          </p:cNvPr>
          <p:cNvSpPr txBox="1"/>
          <p:nvPr/>
        </p:nvSpPr>
        <p:spPr>
          <a:xfrm>
            <a:off x="6113886" y="133275"/>
            <a:ext cx="753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bf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in LSA</a:t>
            </a:r>
          </a:p>
        </p:txBody>
      </p:sp>
      <p:sp>
        <p:nvSpPr>
          <p:cNvPr id="113" name="TextBox 103">
            <a:extLst>
              <a:ext uri="{FF2B5EF4-FFF2-40B4-BE49-F238E27FC236}">
                <a16:creationId xmlns:a16="http://schemas.microsoft.com/office/drawing/2014/main" id="{7A9E3B32-6C32-4DF1-940E-EFAFC8823E48}"/>
              </a:ext>
            </a:extLst>
          </p:cNvPr>
          <p:cNvSpPr txBox="1"/>
          <p:nvPr/>
        </p:nvSpPr>
        <p:spPr>
          <a:xfrm>
            <a:off x="6113886" y="928404"/>
            <a:ext cx="8810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ol-0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 LSA</a:t>
            </a:r>
          </a:p>
        </p:txBody>
      </p:sp>
      <p:sp>
        <p:nvSpPr>
          <p:cNvPr id="115" name="TextBox 103">
            <a:extLst>
              <a:ext uri="{FF2B5EF4-FFF2-40B4-BE49-F238E27FC236}">
                <a16:creationId xmlns:a16="http://schemas.microsoft.com/office/drawing/2014/main" id="{6D07C306-6F71-4BF0-AF55-A5A202122BFD}"/>
              </a:ext>
            </a:extLst>
          </p:cNvPr>
          <p:cNvSpPr txBox="1"/>
          <p:nvPr/>
        </p:nvSpPr>
        <p:spPr>
          <a:xfrm>
            <a:off x="6113886" y="1538375"/>
            <a:ext cx="753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bf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in CEF</a:t>
            </a:r>
          </a:p>
        </p:txBody>
      </p:sp>
      <p:sp>
        <p:nvSpPr>
          <p:cNvPr id="116" name="TextBox 103">
            <a:extLst>
              <a:ext uri="{FF2B5EF4-FFF2-40B4-BE49-F238E27FC236}">
                <a16:creationId xmlns:a16="http://schemas.microsoft.com/office/drawing/2014/main" id="{382419FF-8C0D-4878-86A2-812B86FBBC8C}"/>
              </a:ext>
            </a:extLst>
          </p:cNvPr>
          <p:cNvSpPr txBox="1"/>
          <p:nvPr/>
        </p:nvSpPr>
        <p:spPr>
          <a:xfrm>
            <a:off x="6113886" y="2066229"/>
            <a:ext cx="9668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l-0 in CEF</a:t>
            </a:r>
          </a:p>
        </p:txBody>
      </p:sp>
      <p:sp>
        <p:nvSpPr>
          <p:cNvPr id="117" name="TextBox 103">
            <a:extLst>
              <a:ext uri="{FF2B5EF4-FFF2-40B4-BE49-F238E27FC236}">
                <a16:creationId xmlns:a16="http://schemas.microsoft.com/office/drawing/2014/main" id="{D664CE25-90E5-4663-B500-5B258131C1BB}"/>
              </a:ext>
            </a:extLst>
          </p:cNvPr>
          <p:cNvSpPr txBox="1"/>
          <p:nvPr/>
        </p:nvSpPr>
        <p:spPr>
          <a:xfrm>
            <a:off x="6173934" y="4376573"/>
            <a:ext cx="753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bf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in LSA</a:t>
            </a:r>
          </a:p>
        </p:txBody>
      </p:sp>
      <p:sp>
        <p:nvSpPr>
          <p:cNvPr id="118" name="TextBox 103">
            <a:extLst>
              <a:ext uri="{FF2B5EF4-FFF2-40B4-BE49-F238E27FC236}">
                <a16:creationId xmlns:a16="http://schemas.microsoft.com/office/drawing/2014/main" id="{2E51A1CA-195A-4609-AB2A-312A2AB79C3E}"/>
              </a:ext>
            </a:extLst>
          </p:cNvPr>
          <p:cNvSpPr txBox="1"/>
          <p:nvPr/>
        </p:nvSpPr>
        <p:spPr>
          <a:xfrm>
            <a:off x="6113886" y="3032084"/>
            <a:ext cx="878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ol-0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 LSA</a:t>
            </a:r>
          </a:p>
        </p:txBody>
      </p:sp>
      <p:sp>
        <p:nvSpPr>
          <p:cNvPr id="119" name="TextBox 103">
            <a:extLst>
              <a:ext uri="{FF2B5EF4-FFF2-40B4-BE49-F238E27FC236}">
                <a16:creationId xmlns:a16="http://schemas.microsoft.com/office/drawing/2014/main" id="{AFE29DD4-3DD2-47C3-8D1A-90D9A5F314DD}"/>
              </a:ext>
            </a:extLst>
          </p:cNvPr>
          <p:cNvSpPr txBox="1"/>
          <p:nvPr/>
        </p:nvSpPr>
        <p:spPr>
          <a:xfrm>
            <a:off x="6179198" y="4683149"/>
            <a:ext cx="753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bf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in CEF</a:t>
            </a:r>
          </a:p>
        </p:txBody>
      </p:sp>
      <p:sp>
        <p:nvSpPr>
          <p:cNvPr id="120" name="TextBox 103">
            <a:extLst>
              <a:ext uri="{FF2B5EF4-FFF2-40B4-BE49-F238E27FC236}">
                <a16:creationId xmlns:a16="http://schemas.microsoft.com/office/drawing/2014/main" id="{792809E0-F687-4184-8934-A354B1D2ABC7}"/>
              </a:ext>
            </a:extLst>
          </p:cNvPr>
          <p:cNvSpPr txBox="1"/>
          <p:nvPr/>
        </p:nvSpPr>
        <p:spPr>
          <a:xfrm>
            <a:off x="6113886" y="3824266"/>
            <a:ext cx="9668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l-0 in CEF</a:t>
            </a:r>
          </a:p>
        </p:txBody>
      </p:sp>
      <p:sp>
        <p:nvSpPr>
          <p:cNvPr id="121" name="TextBox 103">
            <a:extLst>
              <a:ext uri="{FF2B5EF4-FFF2-40B4-BE49-F238E27FC236}">
                <a16:creationId xmlns:a16="http://schemas.microsoft.com/office/drawing/2014/main" id="{DB3CB2DC-1A4B-404A-8422-37C5BA7E2E55}"/>
              </a:ext>
            </a:extLst>
          </p:cNvPr>
          <p:cNvSpPr txBox="1"/>
          <p:nvPr/>
        </p:nvSpPr>
        <p:spPr>
          <a:xfrm>
            <a:off x="6123411" y="7060248"/>
            <a:ext cx="753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lr3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in LSA</a:t>
            </a:r>
          </a:p>
        </p:txBody>
      </p:sp>
      <p:sp>
        <p:nvSpPr>
          <p:cNvPr id="122" name="TextBox 103">
            <a:extLst>
              <a:ext uri="{FF2B5EF4-FFF2-40B4-BE49-F238E27FC236}">
                <a16:creationId xmlns:a16="http://schemas.microsoft.com/office/drawing/2014/main" id="{D8F4D4DE-2C10-4043-A742-404C992E7B05}"/>
              </a:ext>
            </a:extLst>
          </p:cNvPr>
          <p:cNvSpPr txBox="1"/>
          <p:nvPr/>
        </p:nvSpPr>
        <p:spPr>
          <a:xfrm>
            <a:off x="6113886" y="6020754"/>
            <a:ext cx="8787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ol-0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n LSA</a:t>
            </a:r>
          </a:p>
        </p:txBody>
      </p:sp>
      <p:sp>
        <p:nvSpPr>
          <p:cNvPr id="123" name="TextBox 103">
            <a:extLst>
              <a:ext uri="{FF2B5EF4-FFF2-40B4-BE49-F238E27FC236}">
                <a16:creationId xmlns:a16="http://schemas.microsoft.com/office/drawing/2014/main" id="{A6AFA814-73C3-4995-94DD-4474CE664F60}"/>
              </a:ext>
            </a:extLst>
          </p:cNvPr>
          <p:cNvSpPr txBox="1"/>
          <p:nvPr/>
        </p:nvSpPr>
        <p:spPr>
          <a:xfrm>
            <a:off x="6113886" y="8217827"/>
            <a:ext cx="753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lr3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in CEF</a:t>
            </a:r>
          </a:p>
        </p:txBody>
      </p:sp>
      <p:sp>
        <p:nvSpPr>
          <p:cNvPr id="124" name="TextBox 103">
            <a:extLst>
              <a:ext uri="{FF2B5EF4-FFF2-40B4-BE49-F238E27FC236}">
                <a16:creationId xmlns:a16="http://schemas.microsoft.com/office/drawing/2014/main" id="{FC76D745-1906-4EBF-B3E3-161356D976CE}"/>
              </a:ext>
            </a:extLst>
          </p:cNvPr>
          <p:cNvSpPr txBox="1"/>
          <p:nvPr/>
        </p:nvSpPr>
        <p:spPr>
          <a:xfrm>
            <a:off x="6113886" y="7667991"/>
            <a:ext cx="8080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l-0 in CEF</a:t>
            </a:r>
          </a:p>
        </p:txBody>
      </p:sp>
      <p:graphicFrame>
        <p:nvGraphicFramePr>
          <p:cNvPr id="125" name="内容占位符 3">
            <a:extLst>
              <a:ext uri="{FF2B5EF4-FFF2-40B4-BE49-F238E27FC236}">
                <a16:creationId xmlns:a16="http://schemas.microsoft.com/office/drawing/2014/main" id="{A4022B03-0FBB-4CD1-86A1-E8886A7352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6104237"/>
              </p:ext>
            </p:extLst>
          </p:nvPr>
        </p:nvGraphicFramePr>
        <p:xfrm>
          <a:off x="213652" y="15344"/>
          <a:ext cx="6708276" cy="28927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8" name="TextBox 55">
            <a:extLst>
              <a:ext uri="{FF2B5EF4-FFF2-40B4-BE49-F238E27FC236}">
                <a16:creationId xmlns:a16="http://schemas.microsoft.com/office/drawing/2014/main" id="{048202D7-C743-4465-BA0B-3ADFCB5AB1EE}"/>
              </a:ext>
            </a:extLst>
          </p:cNvPr>
          <p:cNvSpPr txBox="1"/>
          <p:nvPr/>
        </p:nvSpPr>
        <p:spPr>
          <a:xfrm>
            <a:off x="568368" y="8441386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9" name="TextBox 56">
            <a:extLst>
              <a:ext uri="{FF2B5EF4-FFF2-40B4-BE49-F238E27FC236}">
                <a16:creationId xmlns:a16="http://schemas.microsoft.com/office/drawing/2014/main" id="{152B20C8-7C8C-468E-AADC-268251CB6161}"/>
              </a:ext>
            </a:extLst>
          </p:cNvPr>
          <p:cNvSpPr txBox="1"/>
          <p:nvPr/>
        </p:nvSpPr>
        <p:spPr>
          <a:xfrm>
            <a:off x="1202563" y="844138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20" name="TextBox 57">
            <a:extLst>
              <a:ext uri="{FF2B5EF4-FFF2-40B4-BE49-F238E27FC236}">
                <a16:creationId xmlns:a16="http://schemas.microsoft.com/office/drawing/2014/main" id="{43603318-D312-4D27-AE35-D5D73CE8FDA5}"/>
              </a:ext>
            </a:extLst>
          </p:cNvPr>
          <p:cNvSpPr txBox="1"/>
          <p:nvPr/>
        </p:nvSpPr>
        <p:spPr>
          <a:xfrm>
            <a:off x="1792441" y="844138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21" name="TextBox 58">
            <a:extLst>
              <a:ext uri="{FF2B5EF4-FFF2-40B4-BE49-F238E27FC236}">
                <a16:creationId xmlns:a16="http://schemas.microsoft.com/office/drawing/2014/main" id="{7054EA54-EE4C-41DD-9760-641CAE55C865}"/>
              </a:ext>
            </a:extLst>
          </p:cNvPr>
          <p:cNvSpPr txBox="1"/>
          <p:nvPr/>
        </p:nvSpPr>
        <p:spPr>
          <a:xfrm>
            <a:off x="2431064" y="844138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2" name="TextBox 59">
            <a:extLst>
              <a:ext uri="{FF2B5EF4-FFF2-40B4-BE49-F238E27FC236}">
                <a16:creationId xmlns:a16="http://schemas.microsoft.com/office/drawing/2014/main" id="{3606E418-1820-40DE-86BA-EB768E47D957}"/>
              </a:ext>
            </a:extLst>
          </p:cNvPr>
          <p:cNvSpPr txBox="1"/>
          <p:nvPr/>
        </p:nvSpPr>
        <p:spPr>
          <a:xfrm>
            <a:off x="3047326" y="844138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23" name="TextBox 60">
            <a:extLst>
              <a:ext uri="{FF2B5EF4-FFF2-40B4-BE49-F238E27FC236}">
                <a16:creationId xmlns:a16="http://schemas.microsoft.com/office/drawing/2014/main" id="{FB03C005-7789-45B4-B309-FD287410AD51}"/>
              </a:ext>
            </a:extLst>
          </p:cNvPr>
          <p:cNvSpPr txBox="1"/>
          <p:nvPr/>
        </p:nvSpPr>
        <p:spPr>
          <a:xfrm>
            <a:off x="3697712" y="844138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24" name="TextBox 61">
            <a:extLst>
              <a:ext uri="{FF2B5EF4-FFF2-40B4-BE49-F238E27FC236}">
                <a16:creationId xmlns:a16="http://schemas.microsoft.com/office/drawing/2014/main" id="{94FDBC60-C1DC-433B-821D-84F857327784}"/>
              </a:ext>
            </a:extLst>
          </p:cNvPr>
          <p:cNvSpPr txBox="1"/>
          <p:nvPr/>
        </p:nvSpPr>
        <p:spPr>
          <a:xfrm>
            <a:off x="4326334" y="844138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</p:txBody>
      </p:sp>
      <p:sp>
        <p:nvSpPr>
          <p:cNvPr id="25" name="TextBox 62">
            <a:extLst>
              <a:ext uri="{FF2B5EF4-FFF2-40B4-BE49-F238E27FC236}">
                <a16:creationId xmlns:a16="http://schemas.microsoft.com/office/drawing/2014/main" id="{494ED0D2-323A-4DCE-8864-6DDDAD0C36D0}"/>
              </a:ext>
            </a:extLst>
          </p:cNvPr>
          <p:cNvSpPr txBox="1"/>
          <p:nvPr/>
        </p:nvSpPr>
        <p:spPr>
          <a:xfrm>
            <a:off x="4970516" y="844138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</a:p>
        </p:txBody>
      </p:sp>
      <p:sp>
        <p:nvSpPr>
          <p:cNvPr id="26" name="TextBox 63">
            <a:extLst>
              <a:ext uri="{FF2B5EF4-FFF2-40B4-BE49-F238E27FC236}">
                <a16:creationId xmlns:a16="http://schemas.microsoft.com/office/drawing/2014/main" id="{B4816D56-5F80-4559-B331-9D195E0F73CD}"/>
              </a:ext>
            </a:extLst>
          </p:cNvPr>
          <p:cNvSpPr txBox="1"/>
          <p:nvPr/>
        </p:nvSpPr>
        <p:spPr>
          <a:xfrm>
            <a:off x="5599618" y="844138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7" name="TextBox 64">
            <a:extLst>
              <a:ext uri="{FF2B5EF4-FFF2-40B4-BE49-F238E27FC236}">
                <a16:creationId xmlns:a16="http://schemas.microsoft.com/office/drawing/2014/main" id="{3BEBEAF8-F2F4-46D2-9E96-177D70D1564F}"/>
              </a:ext>
            </a:extLst>
          </p:cNvPr>
          <p:cNvSpPr txBox="1"/>
          <p:nvPr/>
        </p:nvSpPr>
        <p:spPr>
          <a:xfrm>
            <a:off x="6196363" y="8441386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 27</a:t>
            </a:r>
          </a:p>
        </p:txBody>
      </p:sp>
      <p:sp>
        <p:nvSpPr>
          <p:cNvPr id="29" name="TextBox 2">
            <a:extLst>
              <a:ext uri="{FF2B5EF4-FFF2-40B4-BE49-F238E27FC236}">
                <a16:creationId xmlns:a16="http://schemas.microsoft.com/office/drawing/2014/main" id="{8B6F7236-D48E-44E4-94C2-B1A14B784421}"/>
              </a:ext>
            </a:extLst>
          </p:cNvPr>
          <p:cNvSpPr txBox="1"/>
          <p:nvPr/>
        </p:nvSpPr>
        <p:spPr>
          <a:xfrm rot="10800000">
            <a:off x="-23350" y="873770"/>
            <a:ext cx="369332" cy="115993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nt Size, cm2</a:t>
            </a:r>
          </a:p>
        </p:txBody>
      </p:sp>
      <p:sp>
        <p:nvSpPr>
          <p:cNvPr id="30" name="TextBox 2">
            <a:extLst>
              <a:ext uri="{FF2B5EF4-FFF2-40B4-BE49-F238E27FC236}">
                <a16:creationId xmlns:a16="http://schemas.microsoft.com/office/drawing/2014/main" id="{5B50E822-B8B9-4976-83F7-C83A2F7653B1}"/>
              </a:ext>
            </a:extLst>
          </p:cNvPr>
          <p:cNvSpPr txBox="1"/>
          <p:nvPr/>
        </p:nvSpPr>
        <p:spPr>
          <a:xfrm rot="10800000">
            <a:off x="-23350" y="3746502"/>
            <a:ext cx="369332" cy="115993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nt Size, cm2</a:t>
            </a:r>
          </a:p>
        </p:txBody>
      </p:sp>
      <p:sp>
        <p:nvSpPr>
          <p:cNvPr id="31" name="TextBox 2">
            <a:extLst>
              <a:ext uri="{FF2B5EF4-FFF2-40B4-BE49-F238E27FC236}">
                <a16:creationId xmlns:a16="http://schemas.microsoft.com/office/drawing/2014/main" id="{6C07E17B-8CB0-492B-870A-8CDF8CAA667A}"/>
              </a:ext>
            </a:extLst>
          </p:cNvPr>
          <p:cNvSpPr txBox="1"/>
          <p:nvPr/>
        </p:nvSpPr>
        <p:spPr>
          <a:xfrm rot="10800000">
            <a:off x="-23350" y="6599306"/>
            <a:ext cx="369332" cy="115993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nt Size, cm2</a:t>
            </a:r>
          </a:p>
        </p:txBody>
      </p:sp>
      <p:sp>
        <p:nvSpPr>
          <p:cNvPr id="32" name="TextBox 55">
            <a:extLst>
              <a:ext uri="{FF2B5EF4-FFF2-40B4-BE49-F238E27FC236}">
                <a16:creationId xmlns:a16="http://schemas.microsoft.com/office/drawing/2014/main" id="{C7471644-302A-422F-8943-787437A02734}"/>
              </a:ext>
            </a:extLst>
          </p:cNvPr>
          <p:cNvSpPr txBox="1"/>
          <p:nvPr/>
        </p:nvSpPr>
        <p:spPr>
          <a:xfrm>
            <a:off x="570640" y="5720919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33" name="TextBox 56">
            <a:extLst>
              <a:ext uri="{FF2B5EF4-FFF2-40B4-BE49-F238E27FC236}">
                <a16:creationId xmlns:a16="http://schemas.microsoft.com/office/drawing/2014/main" id="{667DEB2F-52DF-4463-B6C9-8E80EEE95B09}"/>
              </a:ext>
            </a:extLst>
          </p:cNvPr>
          <p:cNvSpPr txBox="1"/>
          <p:nvPr/>
        </p:nvSpPr>
        <p:spPr>
          <a:xfrm>
            <a:off x="1204835" y="572091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34" name="TextBox 57">
            <a:extLst>
              <a:ext uri="{FF2B5EF4-FFF2-40B4-BE49-F238E27FC236}">
                <a16:creationId xmlns:a16="http://schemas.microsoft.com/office/drawing/2014/main" id="{F55C7586-7EDD-43E9-9A44-A28ADE8AE9DC}"/>
              </a:ext>
            </a:extLst>
          </p:cNvPr>
          <p:cNvSpPr txBox="1"/>
          <p:nvPr/>
        </p:nvSpPr>
        <p:spPr>
          <a:xfrm>
            <a:off x="1794713" y="572091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35" name="TextBox 58">
            <a:extLst>
              <a:ext uri="{FF2B5EF4-FFF2-40B4-BE49-F238E27FC236}">
                <a16:creationId xmlns:a16="http://schemas.microsoft.com/office/drawing/2014/main" id="{562330C2-2D34-4276-BE01-7369C3978556}"/>
              </a:ext>
            </a:extLst>
          </p:cNvPr>
          <p:cNvSpPr txBox="1"/>
          <p:nvPr/>
        </p:nvSpPr>
        <p:spPr>
          <a:xfrm>
            <a:off x="2433336" y="572091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6" name="TextBox 59">
            <a:extLst>
              <a:ext uri="{FF2B5EF4-FFF2-40B4-BE49-F238E27FC236}">
                <a16:creationId xmlns:a16="http://schemas.microsoft.com/office/drawing/2014/main" id="{97D54393-BD20-466A-9714-8FC8A7E5F98F}"/>
              </a:ext>
            </a:extLst>
          </p:cNvPr>
          <p:cNvSpPr txBox="1"/>
          <p:nvPr/>
        </p:nvSpPr>
        <p:spPr>
          <a:xfrm>
            <a:off x="3049598" y="572091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37" name="TextBox 60">
            <a:extLst>
              <a:ext uri="{FF2B5EF4-FFF2-40B4-BE49-F238E27FC236}">
                <a16:creationId xmlns:a16="http://schemas.microsoft.com/office/drawing/2014/main" id="{D98C0905-BE27-4307-81B7-A556457F0E3B}"/>
              </a:ext>
            </a:extLst>
          </p:cNvPr>
          <p:cNvSpPr txBox="1"/>
          <p:nvPr/>
        </p:nvSpPr>
        <p:spPr>
          <a:xfrm>
            <a:off x="3699984" y="572091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38" name="TextBox 61">
            <a:extLst>
              <a:ext uri="{FF2B5EF4-FFF2-40B4-BE49-F238E27FC236}">
                <a16:creationId xmlns:a16="http://schemas.microsoft.com/office/drawing/2014/main" id="{05B327B5-8B2F-4C1B-AEB1-0EF5814A44FF}"/>
              </a:ext>
            </a:extLst>
          </p:cNvPr>
          <p:cNvSpPr txBox="1"/>
          <p:nvPr/>
        </p:nvSpPr>
        <p:spPr>
          <a:xfrm>
            <a:off x="4328606" y="572091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</p:txBody>
      </p:sp>
      <p:sp>
        <p:nvSpPr>
          <p:cNvPr id="39" name="TextBox 62">
            <a:extLst>
              <a:ext uri="{FF2B5EF4-FFF2-40B4-BE49-F238E27FC236}">
                <a16:creationId xmlns:a16="http://schemas.microsoft.com/office/drawing/2014/main" id="{63F32C3A-1508-4433-9E6F-181AD1EB92B8}"/>
              </a:ext>
            </a:extLst>
          </p:cNvPr>
          <p:cNvSpPr txBox="1"/>
          <p:nvPr/>
        </p:nvSpPr>
        <p:spPr>
          <a:xfrm>
            <a:off x="4972788" y="572091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</a:p>
        </p:txBody>
      </p:sp>
      <p:sp>
        <p:nvSpPr>
          <p:cNvPr id="40" name="TextBox 63">
            <a:extLst>
              <a:ext uri="{FF2B5EF4-FFF2-40B4-BE49-F238E27FC236}">
                <a16:creationId xmlns:a16="http://schemas.microsoft.com/office/drawing/2014/main" id="{A223E1B8-959E-4C8F-A5BE-5A1D4D1458A6}"/>
              </a:ext>
            </a:extLst>
          </p:cNvPr>
          <p:cNvSpPr txBox="1"/>
          <p:nvPr/>
        </p:nvSpPr>
        <p:spPr>
          <a:xfrm>
            <a:off x="5601890" y="572091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41" name="TextBox 64">
            <a:extLst>
              <a:ext uri="{FF2B5EF4-FFF2-40B4-BE49-F238E27FC236}">
                <a16:creationId xmlns:a16="http://schemas.microsoft.com/office/drawing/2014/main" id="{5E4DA925-0417-4AC5-84AF-E7DF53657E71}"/>
              </a:ext>
            </a:extLst>
          </p:cNvPr>
          <p:cNvSpPr txBox="1"/>
          <p:nvPr/>
        </p:nvSpPr>
        <p:spPr>
          <a:xfrm>
            <a:off x="6198635" y="5720919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 27</a:t>
            </a:r>
          </a:p>
        </p:txBody>
      </p:sp>
      <p:sp>
        <p:nvSpPr>
          <p:cNvPr id="42" name="TextBox 55">
            <a:extLst>
              <a:ext uri="{FF2B5EF4-FFF2-40B4-BE49-F238E27FC236}">
                <a16:creationId xmlns:a16="http://schemas.microsoft.com/office/drawing/2014/main" id="{DF2F5975-7C28-49B5-AD31-1FB8B99C0214}"/>
              </a:ext>
            </a:extLst>
          </p:cNvPr>
          <p:cNvSpPr txBox="1"/>
          <p:nvPr/>
        </p:nvSpPr>
        <p:spPr>
          <a:xfrm>
            <a:off x="572912" y="2768440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43" name="TextBox 56">
            <a:extLst>
              <a:ext uri="{FF2B5EF4-FFF2-40B4-BE49-F238E27FC236}">
                <a16:creationId xmlns:a16="http://schemas.microsoft.com/office/drawing/2014/main" id="{68037F24-4EBC-4F51-A4A5-732618655959}"/>
              </a:ext>
            </a:extLst>
          </p:cNvPr>
          <p:cNvSpPr txBox="1"/>
          <p:nvPr/>
        </p:nvSpPr>
        <p:spPr>
          <a:xfrm>
            <a:off x="1207107" y="276844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44" name="TextBox 57">
            <a:extLst>
              <a:ext uri="{FF2B5EF4-FFF2-40B4-BE49-F238E27FC236}">
                <a16:creationId xmlns:a16="http://schemas.microsoft.com/office/drawing/2014/main" id="{5C6F8623-7F9D-4FC1-B4BE-D4268642246B}"/>
              </a:ext>
            </a:extLst>
          </p:cNvPr>
          <p:cNvSpPr txBox="1"/>
          <p:nvPr/>
        </p:nvSpPr>
        <p:spPr>
          <a:xfrm>
            <a:off x="1796985" y="276844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45" name="TextBox 58">
            <a:extLst>
              <a:ext uri="{FF2B5EF4-FFF2-40B4-BE49-F238E27FC236}">
                <a16:creationId xmlns:a16="http://schemas.microsoft.com/office/drawing/2014/main" id="{827A92BD-4C8F-47B8-B8D6-5028F4469BA3}"/>
              </a:ext>
            </a:extLst>
          </p:cNvPr>
          <p:cNvSpPr txBox="1"/>
          <p:nvPr/>
        </p:nvSpPr>
        <p:spPr>
          <a:xfrm>
            <a:off x="2435608" y="276844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46" name="TextBox 59">
            <a:extLst>
              <a:ext uri="{FF2B5EF4-FFF2-40B4-BE49-F238E27FC236}">
                <a16:creationId xmlns:a16="http://schemas.microsoft.com/office/drawing/2014/main" id="{9F6B8C70-31F7-43C9-AAD4-7DA3F07B1B57}"/>
              </a:ext>
            </a:extLst>
          </p:cNvPr>
          <p:cNvSpPr txBox="1"/>
          <p:nvPr/>
        </p:nvSpPr>
        <p:spPr>
          <a:xfrm>
            <a:off x="3051870" y="276844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47" name="TextBox 60">
            <a:extLst>
              <a:ext uri="{FF2B5EF4-FFF2-40B4-BE49-F238E27FC236}">
                <a16:creationId xmlns:a16="http://schemas.microsoft.com/office/drawing/2014/main" id="{E90F1E9B-0B6A-4C41-844E-046F36442C8A}"/>
              </a:ext>
            </a:extLst>
          </p:cNvPr>
          <p:cNvSpPr txBox="1"/>
          <p:nvPr/>
        </p:nvSpPr>
        <p:spPr>
          <a:xfrm>
            <a:off x="3702256" y="276844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48" name="TextBox 61">
            <a:extLst>
              <a:ext uri="{FF2B5EF4-FFF2-40B4-BE49-F238E27FC236}">
                <a16:creationId xmlns:a16="http://schemas.microsoft.com/office/drawing/2014/main" id="{91AE1155-E7CA-4611-9EB4-E215B19981DB}"/>
              </a:ext>
            </a:extLst>
          </p:cNvPr>
          <p:cNvSpPr txBox="1"/>
          <p:nvPr/>
        </p:nvSpPr>
        <p:spPr>
          <a:xfrm>
            <a:off x="4330878" y="276844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</p:txBody>
      </p:sp>
      <p:sp>
        <p:nvSpPr>
          <p:cNvPr id="49" name="TextBox 62">
            <a:extLst>
              <a:ext uri="{FF2B5EF4-FFF2-40B4-BE49-F238E27FC236}">
                <a16:creationId xmlns:a16="http://schemas.microsoft.com/office/drawing/2014/main" id="{F0548FDB-7581-4080-92C1-EA4A0053469B}"/>
              </a:ext>
            </a:extLst>
          </p:cNvPr>
          <p:cNvSpPr txBox="1"/>
          <p:nvPr/>
        </p:nvSpPr>
        <p:spPr>
          <a:xfrm>
            <a:off x="4975060" y="276844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</a:p>
        </p:txBody>
      </p:sp>
      <p:sp>
        <p:nvSpPr>
          <p:cNvPr id="50" name="TextBox 63">
            <a:extLst>
              <a:ext uri="{FF2B5EF4-FFF2-40B4-BE49-F238E27FC236}">
                <a16:creationId xmlns:a16="http://schemas.microsoft.com/office/drawing/2014/main" id="{CB0F597D-807D-43C3-B0C0-60E456368287}"/>
              </a:ext>
            </a:extLst>
          </p:cNvPr>
          <p:cNvSpPr txBox="1"/>
          <p:nvPr/>
        </p:nvSpPr>
        <p:spPr>
          <a:xfrm>
            <a:off x="5604162" y="276844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1" name="TextBox 64">
            <a:extLst>
              <a:ext uri="{FF2B5EF4-FFF2-40B4-BE49-F238E27FC236}">
                <a16:creationId xmlns:a16="http://schemas.microsoft.com/office/drawing/2014/main" id="{7728361E-747D-4883-9452-7C15D748AAD2}"/>
              </a:ext>
            </a:extLst>
          </p:cNvPr>
          <p:cNvSpPr txBox="1"/>
          <p:nvPr/>
        </p:nvSpPr>
        <p:spPr>
          <a:xfrm>
            <a:off x="6200907" y="276844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 27</a:t>
            </a:r>
          </a:p>
        </p:txBody>
      </p:sp>
      <p:sp>
        <p:nvSpPr>
          <p:cNvPr id="52" name="TextBox 43">
            <a:extLst>
              <a:ext uri="{FF2B5EF4-FFF2-40B4-BE49-F238E27FC236}">
                <a16:creationId xmlns:a16="http://schemas.microsoft.com/office/drawing/2014/main" id="{6B296B2C-AA04-4F49-AD6F-3232AFE5FB92}"/>
              </a:ext>
            </a:extLst>
          </p:cNvPr>
          <p:cNvSpPr txBox="1"/>
          <p:nvPr/>
        </p:nvSpPr>
        <p:spPr>
          <a:xfrm>
            <a:off x="36328" y="289232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3" name="TextBox 44">
            <a:extLst>
              <a:ext uri="{FF2B5EF4-FFF2-40B4-BE49-F238E27FC236}">
                <a16:creationId xmlns:a16="http://schemas.microsoft.com/office/drawing/2014/main" id="{A4EF04E1-01C3-42B3-8918-74A18B0C860A}"/>
              </a:ext>
            </a:extLst>
          </p:cNvPr>
          <p:cNvSpPr txBox="1"/>
          <p:nvPr/>
        </p:nvSpPr>
        <p:spPr>
          <a:xfrm>
            <a:off x="36328" y="4752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4" name="TextBox 45">
            <a:extLst>
              <a:ext uri="{FF2B5EF4-FFF2-40B4-BE49-F238E27FC236}">
                <a16:creationId xmlns:a16="http://schemas.microsoft.com/office/drawing/2014/main" id="{F6DDEC10-8154-4178-B07E-85DE1DC6FEDC}"/>
              </a:ext>
            </a:extLst>
          </p:cNvPr>
          <p:cNvSpPr txBox="1"/>
          <p:nvPr/>
        </p:nvSpPr>
        <p:spPr>
          <a:xfrm>
            <a:off x="36328" y="581469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7166933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3"/>
          <p:cNvGraphicFramePr>
            <a:graphicFrameLocks noGrp="1"/>
          </p:cNvGraphicFramePr>
          <p:nvPr>
            <p:ph idx="1"/>
            <p:extLst/>
          </p:nvPr>
        </p:nvGraphicFramePr>
        <p:xfrm>
          <a:off x="377884" y="2777874"/>
          <a:ext cx="3196503" cy="2529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ontent Placeholder 5"/>
          <p:cNvGraphicFramePr>
            <a:graphicFrameLocks/>
          </p:cNvGraphicFramePr>
          <p:nvPr>
            <p:extLst/>
          </p:nvPr>
        </p:nvGraphicFramePr>
        <p:xfrm>
          <a:off x="354658" y="5364775"/>
          <a:ext cx="3194463" cy="26006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TextBox 19"/>
          <p:cNvSpPr txBox="1"/>
          <p:nvPr/>
        </p:nvSpPr>
        <p:spPr>
          <a:xfrm>
            <a:off x="918732" y="280300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9"/>
          <p:cNvSpPr txBox="1"/>
          <p:nvPr/>
        </p:nvSpPr>
        <p:spPr>
          <a:xfrm>
            <a:off x="2945038" y="3447968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" name="TextBox 19"/>
          <p:cNvSpPr txBox="1"/>
          <p:nvPr/>
        </p:nvSpPr>
        <p:spPr>
          <a:xfrm>
            <a:off x="2281550" y="330183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9"/>
          <p:cNvSpPr txBox="1"/>
          <p:nvPr/>
        </p:nvSpPr>
        <p:spPr>
          <a:xfrm>
            <a:off x="1593026" y="3173637"/>
            <a:ext cx="316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2"/>
          <p:cNvSpPr txBox="1"/>
          <p:nvPr/>
        </p:nvSpPr>
        <p:spPr>
          <a:xfrm rot="10800000">
            <a:off x="61496" y="3631177"/>
            <a:ext cx="369332" cy="44178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</a:p>
        </p:txBody>
      </p:sp>
      <p:sp>
        <p:nvSpPr>
          <p:cNvPr id="16" name="TextBox 15"/>
          <p:cNvSpPr txBox="1"/>
          <p:nvPr/>
        </p:nvSpPr>
        <p:spPr>
          <a:xfrm rot="16200000">
            <a:off x="1523353" y="5177988"/>
            <a:ext cx="369332" cy="30553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n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837112" y="5101845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2905593" y="5177988"/>
            <a:ext cx="369332" cy="30553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n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2207477" y="5101846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91492" y="5934112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19"/>
          <p:cNvSpPr txBox="1"/>
          <p:nvPr/>
        </p:nvSpPr>
        <p:spPr>
          <a:xfrm>
            <a:off x="2929673" y="648407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TextBox 19"/>
          <p:cNvSpPr txBox="1"/>
          <p:nvPr/>
        </p:nvSpPr>
        <p:spPr>
          <a:xfrm>
            <a:off x="2254310" y="638543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Box 19"/>
          <p:cNvSpPr txBox="1"/>
          <p:nvPr/>
        </p:nvSpPr>
        <p:spPr>
          <a:xfrm>
            <a:off x="1577764" y="5675365"/>
            <a:ext cx="316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1484238" y="7858358"/>
            <a:ext cx="369332" cy="29591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ilr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818013" y="7777406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2878353" y="7858358"/>
            <a:ext cx="369332" cy="29591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ilr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2180237" y="7777406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graphicFrame>
        <p:nvGraphicFramePr>
          <p:cNvPr id="28" name="Chart 27"/>
          <p:cNvGraphicFramePr>
            <a:graphicFrameLocks/>
          </p:cNvGraphicFramePr>
          <p:nvPr>
            <p:extLst/>
          </p:nvPr>
        </p:nvGraphicFramePr>
        <p:xfrm>
          <a:off x="356321" y="85294"/>
          <a:ext cx="3194462" cy="25369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9" name="TextBox 28"/>
          <p:cNvSpPr txBox="1"/>
          <p:nvPr/>
        </p:nvSpPr>
        <p:spPr>
          <a:xfrm rot="16200000">
            <a:off x="1520846" y="2435614"/>
            <a:ext cx="369332" cy="3824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zfp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834605" y="2397943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2903086" y="2435614"/>
            <a:ext cx="369332" cy="3824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zfp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2204970" y="2397943"/>
            <a:ext cx="369332" cy="45781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93485" y="494172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4" name="TextBox 19"/>
          <p:cNvSpPr txBox="1"/>
          <p:nvPr/>
        </p:nvSpPr>
        <p:spPr>
          <a:xfrm>
            <a:off x="2947465" y="86125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5" name="TextBox 19"/>
          <p:cNvSpPr txBox="1"/>
          <p:nvPr/>
        </p:nvSpPr>
        <p:spPr>
          <a:xfrm>
            <a:off x="2272102" y="9256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6" name="TextBox 19"/>
          <p:cNvSpPr txBox="1"/>
          <p:nvPr/>
        </p:nvSpPr>
        <p:spPr>
          <a:xfrm>
            <a:off x="1579654" y="326810"/>
            <a:ext cx="316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37" name="Straight Connector 36"/>
          <p:cNvCxnSpPr/>
          <p:nvPr/>
        </p:nvCxnSpPr>
        <p:spPr>
          <a:xfrm>
            <a:off x="951878" y="8157434"/>
            <a:ext cx="849404" cy="0"/>
          </a:xfrm>
          <a:prstGeom prst="line">
            <a:avLst/>
          </a:prstGeom>
          <a:ln w="9525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877687" y="8187997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ean CEF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231840" y="8187997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ress LSA</a:t>
            </a:r>
          </a:p>
        </p:txBody>
      </p:sp>
      <p:sp>
        <p:nvSpPr>
          <p:cNvPr id="41" name="TextBox 2"/>
          <p:cNvSpPr txBox="1"/>
          <p:nvPr/>
        </p:nvSpPr>
        <p:spPr>
          <a:xfrm rot="10800000">
            <a:off x="49707" y="1118063"/>
            <a:ext cx="369332" cy="44178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</a:p>
        </p:txBody>
      </p:sp>
      <p:sp>
        <p:nvSpPr>
          <p:cNvPr id="42" name="TextBox 2"/>
          <p:cNvSpPr txBox="1"/>
          <p:nvPr/>
        </p:nvSpPr>
        <p:spPr>
          <a:xfrm rot="10800000">
            <a:off x="49707" y="6385434"/>
            <a:ext cx="369332" cy="44178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98181" y="280604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86392" y="14037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86392" y="542229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49" name="Straight Connector 48"/>
          <p:cNvCxnSpPr/>
          <p:nvPr/>
        </p:nvCxnSpPr>
        <p:spPr>
          <a:xfrm>
            <a:off x="2272724" y="8157434"/>
            <a:ext cx="849404" cy="0"/>
          </a:xfrm>
          <a:prstGeom prst="line">
            <a:avLst/>
          </a:prstGeom>
          <a:ln w="9525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19">
            <a:extLst>
              <a:ext uri="{FF2B5EF4-FFF2-40B4-BE49-F238E27FC236}">
                <a16:creationId xmlns:a16="http://schemas.microsoft.com/office/drawing/2014/main" id="{9F01ACA7-3FC9-43D5-BADC-8B6615CF1515}"/>
              </a:ext>
            </a:extLst>
          </p:cNvPr>
          <p:cNvSpPr txBox="1"/>
          <p:nvPr/>
        </p:nvSpPr>
        <p:spPr>
          <a:xfrm>
            <a:off x="343743" y="4811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8" name="TextBox 19">
            <a:extLst>
              <a:ext uri="{FF2B5EF4-FFF2-40B4-BE49-F238E27FC236}">
                <a16:creationId xmlns:a16="http://schemas.microsoft.com/office/drawing/2014/main" id="{D1519DF9-6A87-4988-B059-22563933BE71}"/>
              </a:ext>
            </a:extLst>
          </p:cNvPr>
          <p:cNvSpPr txBox="1"/>
          <p:nvPr/>
        </p:nvSpPr>
        <p:spPr>
          <a:xfrm>
            <a:off x="343743" y="8576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50" name="TextBox 19">
            <a:extLst>
              <a:ext uri="{FF2B5EF4-FFF2-40B4-BE49-F238E27FC236}">
                <a16:creationId xmlns:a16="http://schemas.microsoft.com/office/drawing/2014/main" id="{B7552367-02D6-4F5E-9FBF-A4054C7F8E9E}"/>
              </a:ext>
            </a:extLst>
          </p:cNvPr>
          <p:cNvSpPr txBox="1"/>
          <p:nvPr/>
        </p:nvSpPr>
        <p:spPr>
          <a:xfrm>
            <a:off x="343743" y="123261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51" name="TextBox 19">
            <a:extLst>
              <a:ext uri="{FF2B5EF4-FFF2-40B4-BE49-F238E27FC236}">
                <a16:creationId xmlns:a16="http://schemas.microsoft.com/office/drawing/2014/main" id="{F6772A3F-F1AE-454D-B8E8-786FBB318245}"/>
              </a:ext>
            </a:extLst>
          </p:cNvPr>
          <p:cNvSpPr txBox="1"/>
          <p:nvPr/>
        </p:nvSpPr>
        <p:spPr>
          <a:xfrm>
            <a:off x="343743" y="16104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2" name="TextBox 19">
            <a:extLst>
              <a:ext uri="{FF2B5EF4-FFF2-40B4-BE49-F238E27FC236}">
                <a16:creationId xmlns:a16="http://schemas.microsoft.com/office/drawing/2014/main" id="{B928354D-6A1E-45BF-B1D3-3A9D0118F309}"/>
              </a:ext>
            </a:extLst>
          </p:cNvPr>
          <p:cNvSpPr txBox="1"/>
          <p:nvPr/>
        </p:nvSpPr>
        <p:spPr>
          <a:xfrm>
            <a:off x="403165" y="2359142"/>
            <a:ext cx="369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3" name="TextBox 19">
            <a:extLst>
              <a:ext uri="{FF2B5EF4-FFF2-40B4-BE49-F238E27FC236}">
                <a16:creationId xmlns:a16="http://schemas.microsoft.com/office/drawing/2014/main" id="{99539E09-BAE3-4880-AE85-7BAD1034FAE0}"/>
              </a:ext>
            </a:extLst>
          </p:cNvPr>
          <p:cNvSpPr txBox="1"/>
          <p:nvPr/>
        </p:nvSpPr>
        <p:spPr>
          <a:xfrm>
            <a:off x="343743" y="12341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54" name="TextBox 19">
            <a:extLst>
              <a:ext uri="{FF2B5EF4-FFF2-40B4-BE49-F238E27FC236}">
                <a16:creationId xmlns:a16="http://schemas.microsoft.com/office/drawing/2014/main" id="{592FC422-2B49-4F26-8177-FCC15AF98020}"/>
              </a:ext>
            </a:extLst>
          </p:cNvPr>
          <p:cNvSpPr txBox="1"/>
          <p:nvPr/>
        </p:nvSpPr>
        <p:spPr>
          <a:xfrm>
            <a:off x="343743" y="198825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5" name="TextBox 19">
            <a:extLst>
              <a:ext uri="{FF2B5EF4-FFF2-40B4-BE49-F238E27FC236}">
                <a16:creationId xmlns:a16="http://schemas.microsoft.com/office/drawing/2014/main" id="{8012A1A8-C36A-45CD-9B68-1AD7CA79695F}"/>
              </a:ext>
            </a:extLst>
          </p:cNvPr>
          <p:cNvSpPr txBox="1"/>
          <p:nvPr/>
        </p:nvSpPr>
        <p:spPr>
          <a:xfrm>
            <a:off x="343743" y="279722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6" name="TextBox 19">
            <a:extLst>
              <a:ext uri="{FF2B5EF4-FFF2-40B4-BE49-F238E27FC236}">
                <a16:creationId xmlns:a16="http://schemas.microsoft.com/office/drawing/2014/main" id="{DC4D2E36-8FCB-4E22-9503-4748F26D97B8}"/>
              </a:ext>
            </a:extLst>
          </p:cNvPr>
          <p:cNvSpPr txBox="1"/>
          <p:nvPr/>
        </p:nvSpPr>
        <p:spPr>
          <a:xfrm>
            <a:off x="343743" y="32445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57" name="TextBox 19">
            <a:extLst>
              <a:ext uri="{FF2B5EF4-FFF2-40B4-BE49-F238E27FC236}">
                <a16:creationId xmlns:a16="http://schemas.microsoft.com/office/drawing/2014/main" id="{E7FBA86B-E014-429D-A0D1-35D0C56B7AF4}"/>
              </a:ext>
            </a:extLst>
          </p:cNvPr>
          <p:cNvSpPr txBox="1"/>
          <p:nvPr/>
        </p:nvSpPr>
        <p:spPr>
          <a:xfrm>
            <a:off x="343743" y="368388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58" name="TextBox 19">
            <a:extLst>
              <a:ext uri="{FF2B5EF4-FFF2-40B4-BE49-F238E27FC236}">
                <a16:creationId xmlns:a16="http://schemas.microsoft.com/office/drawing/2014/main" id="{277D626C-37AF-471F-85FC-42802BDAEBF9}"/>
              </a:ext>
            </a:extLst>
          </p:cNvPr>
          <p:cNvSpPr txBox="1"/>
          <p:nvPr/>
        </p:nvSpPr>
        <p:spPr>
          <a:xfrm>
            <a:off x="343743" y="413902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9" name="TextBox 19">
            <a:extLst>
              <a:ext uri="{FF2B5EF4-FFF2-40B4-BE49-F238E27FC236}">
                <a16:creationId xmlns:a16="http://schemas.microsoft.com/office/drawing/2014/main" id="{6EC4FC30-56AA-4D56-A7C0-10CD2BF70CD6}"/>
              </a:ext>
            </a:extLst>
          </p:cNvPr>
          <p:cNvSpPr txBox="1"/>
          <p:nvPr/>
        </p:nvSpPr>
        <p:spPr>
          <a:xfrm>
            <a:off x="403166" y="5035790"/>
            <a:ext cx="369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1" name="TextBox 19">
            <a:extLst>
              <a:ext uri="{FF2B5EF4-FFF2-40B4-BE49-F238E27FC236}">
                <a16:creationId xmlns:a16="http://schemas.microsoft.com/office/drawing/2014/main" id="{7AFEE480-13D4-484B-9026-662B59C2D044}"/>
              </a:ext>
            </a:extLst>
          </p:cNvPr>
          <p:cNvSpPr txBox="1"/>
          <p:nvPr/>
        </p:nvSpPr>
        <p:spPr>
          <a:xfrm>
            <a:off x="343743" y="45876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2" name="TextBox 19">
            <a:extLst>
              <a:ext uri="{FF2B5EF4-FFF2-40B4-BE49-F238E27FC236}">
                <a16:creationId xmlns:a16="http://schemas.microsoft.com/office/drawing/2014/main" id="{AC7A2ABF-5790-4C2F-9E31-485220387C97}"/>
              </a:ext>
            </a:extLst>
          </p:cNvPr>
          <p:cNvSpPr txBox="1"/>
          <p:nvPr/>
        </p:nvSpPr>
        <p:spPr>
          <a:xfrm>
            <a:off x="343743" y="53837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63" name="TextBox 19">
            <a:extLst>
              <a:ext uri="{FF2B5EF4-FFF2-40B4-BE49-F238E27FC236}">
                <a16:creationId xmlns:a16="http://schemas.microsoft.com/office/drawing/2014/main" id="{4140B44C-A652-45EC-B470-60924CDB739F}"/>
              </a:ext>
            </a:extLst>
          </p:cNvPr>
          <p:cNvSpPr txBox="1"/>
          <p:nvPr/>
        </p:nvSpPr>
        <p:spPr>
          <a:xfrm>
            <a:off x="343743" y="57087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64" name="TextBox 19">
            <a:extLst>
              <a:ext uri="{FF2B5EF4-FFF2-40B4-BE49-F238E27FC236}">
                <a16:creationId xmlns:a16="http://schemas.microsoft.com/office/drawing/2014/main" id="{9B2A0A1F-338C-445E-B870-026EB0A76846}"/>
              </a:ext>
            </a:extLst>
          </p:cNvPr>
          <p:cNvSpPr txBox="1"/>
          <p:nvPr/>
        </p:nvSpPr>
        <p:spPr>
          <a:xfrm>
            <a:off x="343743" y="604500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65" name="TextBox 19">
            <a:extLst>
              <a:ext uri="{FF2B5EF4-FFF2-40B4-BE49-F238E27FC236}">
                <a16:creationId xmlns:a16="http://schemas.microsoft.com/office/drawing/2014/main" id="{6AA1CEC3-DDCF-4E18-9A68-B36A79EBD07F}"/>
              </a:ext>
            </a:extLst>
          </p:cNvPr>
          <p:cNvSpPr txBox="1"/>
          <p:nvPr/>
        </p:nvSpPr>
        <p:spPr>
          <a:xfrm>
            <a:off x="343743" y="63713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66" name="TextBox 19">
            <a:extLst>
              <a:ext uri="{FF2B5EF4-FFF2-40B4-BE49-F238E27FC236}">
                <a16:creationId xmlns:a16="http://schemas.microsoft.com/office/drawing/2014/main" id="{48A59BAA-F8B4-4C32-BE44-8458D26FEF12}"/>
              </a:ext>
            </a:extLst>
          </p:cNvPr>
          <p:cNvSpPr txBox="1"/>
          <p:nvPr/>
        </p:nvSpPr>
        <p:spPr>
          <a:xfrm>
            <a:off x="409607" y="7698538"/>
            <a:ext cx="3693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7" name="TextBox 19">
            <a:extLst>
              <a:ext uri="{FF2B5EF4-FFF2-40B4-BE49-F238E27FC236}">
                <a16:creationId xmlns:a16="http://schemas.microsoft.com/office/drawing/2014/main" id="{75D67462-05EB-4483-9215-C819A7EAB08C}"/>
              </a:ext>
            </a:extLst>
          </p:cNvPr>
          <p:cNvSpPr txBox="1"/>
          <p:nvPr/>
        </p:nvSpPr>
        <p:spPr>
          <a:xfrm>
            <a:off x="343743" y="67040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68" name="TextBox 19">
            <a:extLst>
              <a:ext uri="{FF2B5EF4-FFF2-40B4-BE49-F238E27FC236}">
                <a16:creationId xmlns:a16="http://schemas.microsoft.com/office/drawing/2014/main" id="{389C58DD-012F-47C2-B117-38BF615BA77F}"/>
              </a:ext>
            </a:extLst>
          </p:cNvPr>
          <p:cNvSpPr txBox="1"/>
          <p:nvPr/>
        </p:nvSpPr>
        <p:spPr>
          <a:xfrm>
            <a:off x="343743" y="70280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69" name="TextBox 19">
            <a:extLst>
              <a:ext uri="{FF2B5EF4-FFF2-40B4-BE49-F238E27FC236}">
                <a16:creationId xmlns:a16="http://schemas.microsoft.com/office/drawing/2014/main" id="{D7221A71-FB1A-479D-B5DA-E01C9D9F98C8}"/>
              </a:ext>
            </a:extLst>
          </p:cNvPr>
          <p:cNvSpPr txBox="1"/>
          <p:nvPr/>
        </p:nvSpPr>
        <p:spPr>
          <a:xfrm>
            <a:off x="343743" y="737312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4277311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12</TotalTime>
  <Words>230</Words>
  <Application>Microsoft Office PowerPoint</Application>
  <PresentationFormat>全屏显示(4:3)</PresentationFormat>
  <Paragraphs>154</Paragraphs>
  <Slides>3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ohua Li</dc:creator>
  <cp:lastModifiedBy>Baohua Li</cp:lastModifiedBy>
  <cp:revision>654</cp:revision>
  <dcterms:created xsi:type="dcterms:W3CDTF">2006-08-16T00:00:00Z</dcterms:created>
  <dcterms:modified xsi:type="dcterms:W3CDTF">2019-03-17T16:57:43Z</dcterms:modified>
</cp:coreProperties>
</file>